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drawings/drawing4.xml" ContentType="application/vnd.openxmlformats-officedocument.drawingml.chartshapes+xml"/>
  <Override PartName="/ppt/charts/chart6.xml" ContentType="application/vnd.openxmlformats-officedocument.drawingml.chart+xml"/>
  <Override PartName="/ppt/drawings/drawing5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32" autoAdjust="0"/>
    <p:restoredTop sz="99591" autoAdjust="0"/>
  </p:normalViewPr>
  <p:slideViewPr>
    <p:cSldViewPr>
      <p:cViewPr varScale="1">
        <p:scale>
          <a:sx n="131" d="100"/>
          <a:sy n="131" d="100"/>
        </p:scale>
        <p:origin x="1248" y="1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package" Target="../embeddings/Microsoft_Excel_Worksheet4.xlsx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5.xml"/><Relationship Id="rId1" Type="http://schemas.openxmlformats.org/officeDocument/2006/relationships/package" Target="../embeddings/Microsoft_Excel_Worksheet5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50"/>
            </a:pPr>
            <a:r>
              <a:rPr lang="en-US" sz="1000" dirty="0" smtClean="0"/>
              <a:t>PEO1- 3PO </a:t>
            </a:r>
            <a:r>
              <a:rPr lang="en-US" sz="1000" dirty="0"/>
              <a:t>&amp; </a:t>
            </a:r>
            <a:r>
              <a:rPr lang="en-US" sz="1000" dirty="0" smtClean="0"/>
              <a:t>Cisplatin</a:t>
            </a:r>
            <a:endParaRPr lang="en-US" sz="1000" dirty="0"/>
          </a:p>
        </c:rich>
      </c:tx>
      <c:layout>
        <c:manualLayout>
          <c:xMode val="edge"/>
          <c:yMode val="edge"/>
          <c:x val="0.30354829246283227"/>
          <c:y val="1.508706842223121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5577559433207694"/>
          <c:y val="0.18375039573855659"/>
          <c:w val="0.78192575987387969"/>
          <c:h val="0.61619210708729888"/>
        </c:manualLayout>
      </c:layout>
      <c:scatterChart>
        <c:scatterStyle val="lineMarker"/>
        <c:varyColors val="0"/>
        <c:ser>
          <c:idx val="0"/>
          <c:order val="0"/>
          <c:tx>
            <c:strRef>
              <c:f>'PEO1 &amp; PEO4'!$B$37:$F$37</c:f>
              <c:strCache>
                <c:ptCount val="1"/>
                <c:pt idx="0">
                  <c:v>3PO</c:v>
                </c:pt>
              </c:strCache>
            </c:strRef>
          </c:tx>
          <c:marker>
            <c:symbol val="diamond"/>
            <c:size val="4"/>
          </c:marker>
          <c:errBars>
            <c:errDir val="y"/>
            <c:errBarType val="both"/>
            <c:errValType val="cust"/>
            <c:noEndCap val="0"/>
            <c:plus>
              <c:numRef>
                <c:f>'PEO1&amp;PEO4 ERROR BARS'!$F$40:$F$46</c:f>
                <c:numCache>
                  <c:formatCode>General</c:formatCode>
                  <c:ptCount val="7"/>
                  <c:pt idx="0">
                    <c:v>2.3578825524258988</c:v>
                  </c:pt>
                  <c:pt idx="1">
                    <c:v>2.4758210460350134</c:v>
                  </c:pt>
                  <c:pt idx="2">
                    <c:v>2.4834998147122249</c:v>
                  </c:pt>
                  <c:pt idx="3">
                    <c:v>2.4360484132016103</c:v>
                  </c:pt>
                  <c:pt idx="4">
                    <c:v>3.8616850542268613</c:v>
                  </c:pt>
                  <c:pt idx="5">
                    <c:v>3.7048863708270563</c:v>
                  </c:pt>
                  <c:pt idx="6">
                    <c:v>0.47999264577563272</c:v>
                  </c:pt>
                </c:numCache>
              </c:numRef>
            </c:plus>
            <c:minus>
              <c:numRef>
                <c:f>'PEO1&amp;PEO4 ERROR BARS'!$F$40:$F$46</c:f>
                <c:numCache>
                  <c:formatCode>General</c:formatCode>
                  <c:ptCount val="7"/>
                  <c:pt idx="0">
                    <c:v>2.3578825524258988</c:v>
                  </c:pt>
                  <c:pt idx="1">
                    <c:v>2.4758210460350134</c:v>
                  </c:pt>
                  <c:pt idx="2">
                    <c:v>2.4834998147122249</c:v>
                  </c:pt>
                  <c:pt idx="3">
                    <c:v>2.4360484132016103</c:v>
                  </c:pt>
                  <c:pt idx="4">
                    <c:v>3.8616850542268613</c:v>
                  </c:pt>
                  <c:pt idx="5">
                    <c:v>3.7048863708270563</c:v>
                  </c:pt>
                  <c:pt idx="6">
                    <c:v>0.47999264577563272</c:v>
                  </c:pt>
                </c:numCache>
              </c:numRef>
            </c:minus>
          </c:errBars>
          <c:xVal>
            <c:numRef>
              <c:f>'PEO1 &amp; PEO4'!$B$40:$B$46</c:f>
              <c:numCache>
                <c:formatCode>General</c:formatCode>
                <c:ptCount val="7"/>
                <c:pt idx="0">
                  <c:v>0.46875</c:v>
                </c:pt>
                <c:pt idx="1">
                  <c:v>0.9375</c:v>
                </c:pt>
                <c:pt idx="2">
                  <c:v>1.875</c:v>
                </c:pt>
                <c:pt idx="3">
                  <c:v>3.75</c:v>
                </c:pt>
                <c:pt idx="4">
                  <c:v>7.5</c:v>
                </c:pt>
                <c:pt idx="5">
                  <c:v>15</c:v>
                </c:pt>
                <c:pt idx="6">
                  <c:v>30</c:v>
                </c:pt>
              </c:numCache>
            </c:numRef>
          </c:xVal>
          <c:yVal>
            <c:numRef>
              <c:f>'PEO1 &amp; PEO4'!$D$40:$D$46</c:f>
              <c:numCache>
                <c:formatCode>General</c:formatCode>
                <c:ptCount val="7"/>
                <c:pt idx="0">
                  <c:v>97.828152370772841</c:v>
                </c:pt>
                <c:pt idx="1">
                  <c:v>95.886404797957312</c:v>
                </c:pt>
                <c:pt idx="2">
                  <c:v>96.082360975030426</c:v>
                </c:pt>
                <c:pt idx="3">
                  <c:v>92.519521391882648</c:v>
                </c:pt>
                <c:pt idx="4">
                  <c:v>87.52620171610107</c:v>
                </c:pt>
                <c:pt idx="5">
                  <c:v>52.205991508565674</c:v>
                </c:pt>
                <c:pt idx="6">
                  <c:v>4.276892016270300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676-4B9A-B9C6-4D0F31F10FB6}"/>
            </c:ext>
          </c:extLst>
        </c:ser>
        <c:ser>
          <c:idx val="1"/>
          <c:order val="1"/>
          <c:tx>
            <c:strRef>
              <c:f>'PEO1 &amp; PEO4'!$B$55:$D$55</c:f>
              <c:strCache>
                <c:ptCount val="1"/>
                <c:pt idx="0">
                  <c:v>3PO &amp; 0.5μM Cisplatin</c:v>
                </c:pt>
              </c:strCache>
            </c:strRef>
          </c:tx>
          <c:marker>
            <c:symbol val="square"/>
            <c:size val="4"/>
          </c:marker>
          <c:errBars>
            <c:errDir val="y"/>
            <c:errBarType val="both"/>
            <c:errValType val="cust"/>
            <c:noEndCap val="0"/>
            <c:plus>
              <c:numRef>
                <c:f>'PEO1&amp;PEO4 ERROR BARS'!$F$57:$F$63</c:f>
                <c:numCache>
                  <c:formatCode>General</c:formatCode>
                  <c:ptCount val="7"/>
                  <c:pt idx="0">
                    <c:v>2.1279057546160129</c:v>
                  </c:pt>
                  <c:pt idx="1">
                    <c:v>1.4791149019076921</c:v>
                  </c:pt>
                  <c:pt idx="2">
                    <c:v>6.026684276654545</c:v>
                  </c:pt>
                  <c:pt idx="3">
                    <c:v>5.252449115710121</c:v>
                  </c:pt>
                  <c:pt idx="4">
                    <c:v>4.6711904572673895</c:v>
                  </c:pt>
                  <c:pt idx="5">
                    <c:v>3.1791830699993624</c:v>
                  </c:pt>
                  <c:pt idx="6">
                    <c:v>0.21752295516686099</c:v>
                  </c:pt>
                </c:numCache>
              </c:numRef>
            </c:plus>
            <c:minus>
              <c:numRef>
                <c:f>'PEO1&amp;PEO4 ERROR BARS'!$F$57:$F$63</c:f>
                <c:numCache>
                  <c:formatCode>General</c:formatCode>
                  <c:ptCount val="7"/>
                  <c:pt idx="0">
                    <c:v>2.1279057546160129</c:v>
                  </c:pt>
                  <c:pt idx="1">
                    <c:v>1.4791149019076921</c:v>
                  </c:pt>
                  <c:pt idx="2">
                    <c:v>6.026684276654545</c:v>
                  </c:pt>
                  <c:pt idx="3">
                    <c:v>5.252449115710121</c:v>
                  </c:pt>
                  <c:pt idx="4">
                    <c:v>4.6711904572673895</c:v>
                  </c:pt>
                  <c:pt idx="5">
                    <c:v>3.1791830699993624</c:v>
                  </c:pt>
                  <c:pt idx="6">
                    <c:v>0.21752295516686099</c:v>
                  </c:pt>
                </c:numCache>
              </c:numRef>
            </c:minus>
          </c:errBars>
          <c:xVal>
            <c:numRef>
              <c:f>'PEO1 &amp; PEO4'!$B$57:$B$63</c:f>
              <c:numCache>
                <c:formatCode>General</c:formatCode>
                <c:ptCount val="7"/>
                <c:pt idx="0">
                  <c:v>0.46875</c:v>
                </c:pt>
                <c:pt idx="1">
                  <c:v>0.9375</c:v>
                </c:pt>
                <c:pt idx="2">
                  <c:v>1.875</c:v>
                </c:pt>
                <c:pt idx="3">
                  <c:v>3.75</c:v>
                </c:pt>
                <c:pt idx="4">
                  <c:v>7.5</c:v>
                </c:pt>
                <c:pt idx="5">
                  <c:v>15</c:v>
                </c:pt>
                <c:pt idx="6">
                  <c:v>30</c:v>
                </c:pt>
              </c:numCache>
            </c:numRef>
          </c:xVal>
          <c:yVal>
            <c:numRef>
              <c:f>'PEO1 &amp; PEO4'!$D$57:$D$63</c:f>
              <c:numCache>
                <c:formatCode>General</c:formatCode>
                <c:ptCount val="7"/>
                <c:pt idx="0">
                  <c:v>83.858852171847644</c:v>
                </c:pt>
                <c:pt idx="1">
                  <c:v>90.441198301713129</c:v>
                </c:pt>
                <c:pt idx="2">
                  <c:v>82.384727294320243</c:v>
                </c:pt>
                <c:pt idx="3">
                  <c:v>57.048484308660676</c:v>
                </c:pt>
                <c:pt idx="4">
                  <c:v>49.299308215314277</c:v>
                </c:pt>
                <c:pt idx="5">
                  <c:v>16.102550399334937</c:v>
                </c:pt>
                <c:pt idx="6">
                  <c:v>3.855289332264481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676-4B9A-B9C6-4D0F31F10FB6}"/>
            </c:ext>
          </c:extLst>
        </c:ser>
        <c:ser>
          <c:idx val="2"/>
          <c:order val="2"/>
          <c:tx>
            <c:strRef>
              <c:f>'PEO1&amp;PEO4 ERROR BARS'!$G$56</c:f>
              <c:strCache>
                <c:ptCount val="1"/>
                <c:pt idx="0">
                  <c:v>0.5μΜ Cisplatin</c:v>
                </c:pt>
              </c:strCache>
            </c:strRef>
          </c:tx>
          <c:marker>
            <c:symbol val="none"/>
          </c:marker>
          <c:xVal>
            <c:numRef>
              <c:f>'PEO1&amp;PEO4 ERROR BARS'!$B$57:$B$63</c:f>
              <c:numCache>
                <c:formatCode>General</c:formatCode>
                <c:ptCount val="7"/>
                <c:pt idx="0">
                  <c:v>0.46875</c:v>
                </c:pt>
                <c:pt idx="1">
                  <c:v>0.9375</c:v>
                </c:pt>
                <c:pt idx="2">
                  <c:v>1.875</c:v>
                </c:pt>
                <c:pt idx="3">
                  <c:v>3.75</c:v>
                </c:pt>
                <c:pt idx="4">
                  <c:v>7.5</c:v>
                </c:pt>
                <c:pt idx="5">
                  <c:v>15</c:v>
                </c:pt>
                <c:pt idx="6">
                  <c:v>30</c:v>
                </c:pt>
              </c:numCache>
            </c:numRef>
          </c:xVal>
          <c:yVal>
            <c:numRef>
              <c:f>'PEO1&amp;PEO4 ERROR BARS'!$G$57:$G$63</c:f>
              <c:numCache>
                <c:formatCode>General</c:formatCode>
                <c:ptCount val="7"/>
                <c:pt idx="0">
                  <c:v>88.433000000000007</c:v>
                </c:pt>
                <c:pt idx="1">
                  <c:v>88.433000000000007</c:v>
                </c:pt>
                <c:pt idx="2">
                  <c:v>88.433000000000007</c:v>
                </c:pt>
                <c:pt idx="3">
                  <c:v>88.433000000000007</c:v>
                </c:pt>
                <c:pt idx="4">
                  <c:v>88.433000000000007</c:v>
                </c:pt>
                <c:pt idx="5">
                  <c:v>88.433000000000007</c:v>
                </c:pt>
                <c:pt idx="6">
                  <c:v>88.4330000000000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676-4B9A-B9C6-4D0F31F10F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8103680"/>
        <c:axId val="78105600"/>
      </c:scatterChart>
      <c:valAx>
        <c:axId val="78103680"/>
        <c:scaling>
          <c:logBase val="1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/>
                  <a:t>3PO Concentration, </a:t>
                </a:r>
                <a:r>
                  <a:rPr lang="el-GR" sz="800"/>
                  <a:t>μ</a:t>
                </a:r>
                <a:r>
                  <a:rPr lang="en-US" sz="800"/>
                  <a:t>M</a:t>
                </a:r>
              </a:p>
            </c:rich>
          </c:tx>
          <c:layout>
            <c:manualLayout>
              <c:xMode val="edge"/>
              <c:yMode val="edge"/>
              <c:x val="0.27929751067572978"/>
              <c:y val="0.8740200087790106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78105600"/>
        <c:crosses val="autoZero"/>
        <c:crossBetween val="midCat"/>
      </c:valAx>
      <c:valAx>
        <c:axId val="7810560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% Cell Number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78103680"/>
        <c:crossesAt val="0.1"/>
        <c:crossBetween val="midCat"/>
      </c:valAx>
    </c:plotArea>
    <c:legend>
      <c:legendPos val="r"/>
      <c:layout>
        <c:manualLayout>
          <c:xMode val="edge"/>
          <c:yMode val="edge"/>
          <c:x val="0.14196201589165638"/>
          <c:y val="0.52857603615194226"/>
          <c:w val="0.55605237416281683"/>
          <c:h val="0.20082135426040396"/>
        </c:manualLayout>
      </c:layout>
      <c:overlay val="0"/>
      <c:txPr>
        <a:bodyPr/>
        <a:lstStyle/>
        <a:p>
          <a:pPr>
            <a:defRPr sz="6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50"/>
            </a:pPr>
            <a:r>
              <a:rPr lang="en-US" sz="1000" dirty="0"/>
              <a:t>PEO4 </a:t>
            </a:r>
            <a:r>
              <a:rPr lang="en-US" sz="1000" dirty="0" smtClean="0"/>
              <a:t> -</a:t>
            </a:r>
            <a:r>
              <a:rPr lang="en-US" sz="1000" baseline="0" dirty="0" smtClean="0"/>
              <a:t> </a:t>
            </a:r>
            <a:r>
              <a:rPr lang="en-US" sz="1000" dirty="0" smtClean="0"/>
              <a:t>3PO </a:t>
            </a:r>
            <a:r>
              <a:rPr lang="en-US" sz="1000" dirty="0"/>
              <a:t>&amp; </a:t>
            </a:r>
            <a:r>
              <a:rPr lang="en-US" sz="1000" dirty="0" smtClean="0"/>
              <a:t>Cisplatin</a:t>
            </a:r>
            <a:endParaRPr lang="en-US" sz="1000" dirty="0"/>
          </a:p>
        </c:rich>
      </c:tx>
      <c:layout>
        <c:manualLayout>
          <c:xMode val="edge"/>
          <c:yMode val="edge"/>
          <c:x val="0.25661899264232252"/>
          <c:y val="0.11446768066975438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7420735554857114"/>
          <c:y val="0.25689179561190378"/>
          <c:w val="0.69170851317535242"/>
          <c:h val="0.59434711387980543"/>
        </c:manualLayout>
      </c:layout>
      <c:scatterChart>
        <c:scatterStyle val="lineMarker"/>
        <c:varyColors val="0"/>
        <c:ser>
          <c:idx val="0"/>
          <c:order val="0"/>
          <c:tx>
            <c:strRef>
              <c:f>'PEO1 &amp; PEO4'!$B$37:$F$37</c:f>
              <c:strCache>
                <c:ptCount val="1"/>
                <c:pt idx="0">
                  <c:v>3PO</c:v>
                </c:pt>
              </c:strCache>
            </c:strRef>
          </c:tx>
          <c:marker>
            <c:symbol val="diamond"/>
            <c:size val="4"/>
          </c:marker>
          <c:errBars>
            <c:errDir val="y"/>
            <c:errBarType val="both"/>
            <c:errValType val="cust"/>
            <c:noEndCap val="0"/>
            <c:plus>
              <c:numRef>
                <c:f>'PEO1&amp;PEO4 ERROR BARS'!$J$40:$J$46</c:f>
                <c:numCache>
                  <c:formatCode>General</c:formatCode>
                  <c:ptCount val="7"/>
                  <c:pt idx="0">
                    <c:v>6.6279876978733432</c:v>
                  </c:pt>
                  <c:pt idx="1">
                    <c:v>7.1236883201369778</c:v>
                  </c:pt>
                  <c:pt idx="2">
                    <c:v>4.013031966198966</c:v>
                  </c:pt>
                  <c:pt idx="3">
                    <c:v>3.1425936824735232</c:v>
                  </c:pt>
                  <c:pt idx="4">
                    <c:v>4.1644842448867543</c:v>
                  </c:pt>
                  <c:pt idx="5">
                    <c:v>3.1442120804454805</c:v>
                  </c:pt>
                  <c:pt idx="6">
                    <c:v>3.1388418162357961</c:v>
                  </c:pt>
                </c:numCache>
              </c:numRef>
            </c:plus>
            <c:minus>
              <c:numRef>
                <c:f>'PEO1&amp;PEO4 ERROR BARS'!$J$40:$J$46</c:f>
                <c:numCache>
                  <c:formatCode>General</c:formatCode>
                  <c:ptCount val="7"/>
                  <c:pt idx="0">
                    <c:v>6.6279876978733432</c:v>
                  </c:pt>
                  <c:pt idx="1">
                    <c:v>7.1236883201369778</c:v>
                  </c:pt>
                  <c:pt idx="2">
                    <c:v>4.013031966198966</c:v>
                  </c:pt>
                  <c:pt idx="3">
                    <c:v>3.1425936824735232</c:v>
                  </c:pt>
                  <c:pt idx="4">
                    <c:v>4.1644842448867543</c:v>
                  </c:pt>
                  <c:pt idx="5">
                    <c:v>3.1442120804454805</c:v>
                  </c:pt>
                  <c:pt idx="6">
                    <c:v>3.1388418162357961</c:v>
                  </c:pt>
                </c:numCache>
              </c:numRef>
            </c:minus>
          </c:errBars>
          <c:xVal>
            <c:numRef>
              <c:f>'PEO1 &amp; PEO4'!$B$40:$B$46</c:f>
              <c:numCache>
                <c:formatCode>General</c:formatCode>
                <c:ptCount val="7"/>
                <c:pt idx="0">
                  <c:v>0.46875</c:v>
                </c:pt>
                <c:pt idx="1">
                  <c:v>0.9375</c:v>
                </c:pt>
                <c:pt idx="2">
                  <c:v>1.875</c:v>
                </c:pt>
                <c:pt idx="3">
                  <c:v>3.75</c:v>
                </c:pt>
                <c:pt idx="4">
                  <c:v>7.5</c:v>
                </c:pt>
                <c:pt idx="5">
                  <c:v>15</c:v>
                </c:pt>
                <c:pt idx="6">
                  <c:v>30</c:v>
                </c:pt>
              </c:numCache>
            </c:numRef>
          </c:xVal>
          <c:yVal>
            <c:numRef>
              <c:f>'PEO1 &amp; PEO4'!$F$40:$F$46</c:f>
              <c:numCache>
                <c:formatCode>General</c:formatCode>
                <c:ptCount val="7"/>
                <c:pt idx="0">
                  <c:v>103.12714560830614</c:v>
                </c:pt>
                <c:pt idx="1">
                  <c:v>105.60265427447042</c:v>
                </c:pt>
                <c:pt idx="2">
                  <c:v>105.22586452315164</c:v>
                </c:pt>
                <c:pt idx="3">
                  <c:v>101.83475676128278</c:v>
                </c:pt>
                <c:pt idx="4">
                  <c:v>99.015113455580689</c:v>
                </c:pt>
                <c:pt idx="5">
                  <c:v>79.233651511345542</c:v>
                </c:pt>
                <c:pt idx="6">
                  <c:v>12.4338524658795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6A5-41E5-A3ED-3980EA74832C}"/>
            </c:ext>
          </c:extLst>
        </c:ser>
        <c:ser>
          <c:idx val="1"/>
          <c:order val="1"/>
          <c:tx>
            <c:strRef>
              <c:f>'PEO1 &amp; PEO4'!$B$84:$D$84</c:f>
              <c:strCache>
                <c:ptCount val="1"/>
                <c:pt idx="0">
                  <c:v>3PO &amp; 1μM Cisplatin</c:v>
                </c:pt>
              </c:strCache>
            </c:strRef>
          </c:tx>
          <c:marker>
            <c:symbol val="square"/>
            <c:size val="4"/>
          </c:marker>
          <c:errBars>
            <c:errDir val="y"/>
            <c:errBarType val="both"/>
            <c:errValType val="cust"/>
            <c:noEndCap val="0"/>
            <c:plus>
              <c:numRef>
                <c:f>'PEO1&amp;PEO4 ERROR BARS'!$F$86:$F$92</c:f>
                <c:numCache>
                  <c:formatCode>General</c:formatCode>
                  <c:ptCount val="7"/>
                  <c:pt idx="0">
                    <c:v>3.3384224042060264</c:v>
                  </c:pt>
                  <c:pt idx="1">
                    <c:v>3.6304756542772063</c:v>
                  </c:pt>
                  <c:pt idx="2">
                    <c:v>3.4603990030700706</c:v>
                  </c:pt>
                  <c:pt idx="3">
                    <c:v>2.0616517591342847</c:v>
                  </c:pt>
                  <c:pt idx="4">
                    <c:v>2.3164144013179651</c:v>
                  </c:pt>
                  <c:pt idx="5">
                    <c:v>2.174928882949783</c:v>
                  </c:pt>
                  <c:pt idx="6">
                    <c:v>2.7865379003004018</c:v>
                  </c:pt>
                </c:numCache>
              </c:numRef>
            </c:plus>
            <c:minus>
              <c:numRef>
                <c:f>'PEO1&amp;PEO4 ERROR BARS'!$F$86:$F$92</c:f>
                <c:numCache>
                  <c:formatCode>General</c:formatCode>
                  <c:ptCount val="7"/>
                  <c:pt idx="0">
                    <c:v>3.3384224042060264</c:v>
                  </c:pt>
                  <c:pt idx="1">
                    <c:v>3.6304756542772063</c:v>
                  </c:pt>
                  <c:pt idx="2">
                    <c:v>3.4603990030700706</c:v>
                  </c:pt>
                  <c:pt idx="3">
                    <c:v>2.0616517591342847</c:v>
                  </c:pt>
                  <c:pt idx="4">
                    <c:v>2.3164144013179651</c:v>
                  </c:pt>
                  <c:pt idx="5">
                    <c:v>2.174928882949783</c:v>
                  </c:pt>
                  <c:pt idx="6">
                    <c:v>2.7865379003004018</c:v>
                  </c:pt>
                </c:numCache>
              </c:numRef>
            </c:minus>
          </c:errBars>
          <c:xVal>
            <c:numRef>
              <c:f>'PEO1 &amp; PEO4'!$B$86:$B$92</c:f>
              <c:numCache>
                <c:formatCode>General</c:formatCode>
                <c:ptCount val="7"/>
                <c:pt idx="0">
                  <c:v>0.46875</c:v>
                </c:pt>
                <c:pt idx="1">
                  <c:v>0.9375</c:v>
                </c:pt>
                <c:pt idx="2">
                  <c:v>1.875</c:v>
                </c:pt>
                <c:pt idx="3">
                  <c:v>3.75</c:v>
                </c:pt>
                <c:pt idx="4">
                  <c:v>7.5</c:v>
                </c:pt>
                <c:pt idx="5">
                  <c:v>15</c:v>
                </c:pt>
                <c:pt idx="6">
                  <c:v>30</c:v>
                </c:pt>
              </c:numCache>
            </c:numRef>
          </c:xVal>
          <c:yVal>
            <c:numRef>
              <c:f>'PEO1 &amp; PEO4'!$D$86:$D$92</c:f>
              <c:numCache>
                <c:formatCode>General</c:formatCode>
                <c:ptCount val="7"/>
                <c:pt idx="0">
                  <c:v>99.316545256635692</c:v>
                </c:pt>
                <c:pt idx="1">
                  <c:v>104.02641714812025</c:v>
                </c:pt>
                <c:pt idx="2">
                  <c:v>80.338901448547276</c:v>
                </c:pt>
                <c:pt idx="3">
                  <c:v>75.616469898685409</c:v>
                </c:pt>
                <c:pt idx="4">
                  <c:v>72.501674621116976</c:v>
                </c:pt>
                <c:pt idx="5">
                  <c:v>64.683287281252618</c:v>
                </c:pt>
                <c:pt idx="6">
                  <c:v>10.4217951938373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6A5-41E5-A3ED-3980EA74832C}"/>
            </c:ext>
          </c:extLst>
        </c:ser>
        <c:ser>
          <c:idx val="2"/>
          <c:order val="2"/>
          <c:tx>
            <c:strRef>
              <c:f>'PEO1&amp;PEO4 ERROR BARS'!$G$85</c:f>
              <c:strCache>
                <c:ptCount val="1"/>
                <c:pt idx="0">
                  <c:v>1μM Cisplatin</c:v>
                </c:pt>
              </c:strCache>
            </c:strRef>
          </c:tx>
          <c:marker>
            <c:symbol val="none"/>
          </c:marker>
          <c:xVal>
            <c:numRef>
              <c:f>'PEO1&amp;PEO4 ERROR BARS'!$B$86:$B$92</c:f>
              <c:numCache>
                <c:formatCode>General</c:formatCode>
                <c:ptCount val="7"/>
                <c:pt idx="0">
                  <c:v>0.46875</c:v>
                </c:pt>
                <c:pt idx="1">
                  <c:v>0.9375</c:v>
                </c:pt>
                <c:pt idx="2">
                  <c:v>1.875</c:v>
                </c:pt>
                <c:pt idx="3">
                  <c:v>3.75</c:v>
                </c:pt>
                <c:pt idx="4">
                  <c:v>7.5</c:v>
                </c:pt>
                <c:pt idx="5">
                  <c:v>15</c:v>
                </c:pt>
                <c:pt idx="6">
                  <c:v>30</c:v>
                </c:pt>
              </c:numCache>
            </c:numRef>
          </c:xVal>
          <c:yVal>
            <c:numRef>
              <c:f>'PEO1&amp;PEO4 ERROR BARS'!$G$86:$G$92</c:f>
              <c:numCache>
                <c:formatCode>General</c:formatCode>
                <c:ptCount val="7"/>
                <c:pt idx="0">
                  <c:v>89.613</c:v>
                </c:pt>
                <c:pt idx="1">
                  <c:v>89.613</c:v>
                </c:pt>
                <c:pt idx="2">
                  <c:v>89.613</c:v>
                </c:pt>
                <c:pt idx="3">
                  <c:v>89.613</c:v>
                </c:pt>
                <c:pt idx="4">
                  <c:v>89.613</c:v>
                </c:pt>
                <c:pt idx="5">
                  <c:v>89.613</c:v>
                </c:pt>
                <c:pt idx="6">
                  <c:v>89.61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B6A5-41E5-A3ED-3980EA7483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7609216"/>
        <c:axId val="77611392"/>
      </c:scatterChart>
      <c:valAx>
        <c:axId val="77609216"/>
        <c:scaling>
          <c:logBase val="1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/>
                  <a:t>3PO Concentration, </a:t>
                </a:r>
                <a:r>
                  <a:rPr lang="el-GR" sz="800"/>
                  <a:t>μ</a:t>
                </a:r>
                <a:r>
                  <a:rPr lang="en-US" sz="800"/>
                  <a:t>M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77611392"/>
        <c:crosses val="autoZero"/>
        <c:crossBetween val="midCat"/>
      </c:valAx>
      <c:valAx>
        <c:axId val="7761139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% Cell Number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77609216"/>
        <c:crossesAt val="0.1"/>
        <c:crossBetween val="midCat"/>
      </c:valAx>
    </c:plotArea>
    <c:legend>
      <c:legendPos val="r"/>
      <c:layout>
        <c:manualLayout>
          <c:xMode val="edge"/>
          <c:yMode val="edge"/>
          <c:x val="0.14461989434376812"/>
          <c:y val="0.55909109990022143"/>
          <c:w val="0.57152035254827727"/>
          <c:h val="0.2306442085776747"/>
        </c:manualLayout>
      </c:layout>
      <c:overlay val="0"/>
      <c:txPr>
        <a:bodyPr/>
        <a:lstStyle/>
        <a:p>
          <a:pPr>
            <a:defRPr sz="6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100"/>
            </a:pPr>
            <a:r>
              <a:rPr lang="en-US" sz="1100" dirty="0"/>
              <a:t>PEO1 - 3PO &amp; </a:t>
            </a:r>
            <a:r>
              <a:rPr lang="en-US" sz="1100" dirty="0" smtClean="0"/>
              <a:t>Paclitaxel</a:t>
            </a:r>
            <a:endParaRPr lang="en-US" sz="1100" dirty="0"/>
          </a:p>
        </c:rich>
      </c:tx>
      <c:layout>
        <c:manualLayout>
          <c:xMode val="edge"/>
          <c:yMode val="edge"/>
          <c:x val="0.30702233649365257"/>
          <c:y val="1.8779342723004695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5073688955571329"/>
          <c:y val="0.11561583754472142"/>
          <c:w val="0.76182034091023787"/>
          <c:h val="0.69322802504504899"/>
        </c:manualLayout>
      </c:layout>
      <c:scatterChart>
        <c:scatterStyle val="lineMarker"/>
        <c:varyColors val="0"/>
        <c:ser>
          <c:idx val="0"/>
          <c:order val="0"/>
          <c:tx>
            <c:strRef>
              <c:f>'PEO1 &amp; PEO4'!$B$37:$F$37</c:f>
              <c:strCache>
                <c:ptCount val="1"/>
                <c:pt idx="0">
                  <c:v>3PO</c:v>
                </c:pt>
              </c:strCache>
            </c:strRef>
          </c:tx>
          <c:marker>
            <c:symbol val="diamond"/>
            <c:size val="4"/>
          </c:marker>
          <c:errBars>
            <c:errDir val="y"/>
            <c:errBarType val="both"/>
            <c:errValType val="cust"/>
            <c:noEndCap val="0"/>
            <c:plus>
              <c:numRef>
                <c:f>'PEO1&amp;PEO4 ERROR BARS'!$F$40:$F$46</c:f>
                <c:numCache>
                  <c:formatCode>General</c:formatCode>
                  <c:ptCount val="7"/>
                  <c:pt idx="0">
                    <c:v>2.3578825524258988</c:v>
                  </c:pt>
                  <c:pt idx="1">
                    <c:v>2.4758210460350134</c:v>
                  </c:pt>
                  <c:pt idx="2">
                    <c:v>2.4834998147122249</c:v>
                  </c:pt>
                  <c:pt idx="3">
                    <c:v>2.4360484132016103</c:v>
                  </c:pt>
                  <c:pt idx="4">
                    <c:v>3.8616850542268613</c:v>
                  </c:pt>
                  <c:pt idx="5">
                    <c:v>3.7048863708270563</c:v>
                  </c:pt>
                  <c:pt idx="6">
                    <c:v>0.47999264577563272</c:v>
                  </c:pt>
                </c:numCache>
              </c:numRef>
            </c:plus>
            <c:minus>
              <c:numRef>
                <c:f>'PEO1&amp;PEO4 ERROR BARS'!$F$40:$F$46</c:f>
                <c:numCache>
                  <c:formatCode>General</c:formatCode>
                  <c:ptCount val="7"/>
                  <c:pt idx="0">
                    <c:v>2.3578825524258988</c:v>
                  </c:pt>
                  <c:pt idx="1">
                    <c:v>2.4758210460350134</c:v>
                  </c:pt>
                  <c:pt idx="2">
                    <c:v>2.4834998147122249</c:v>
                  </c:pt>
                  <c:pt idx="3">
                    <c:v>2.4360484132016103</c:v>
                  </c:pt>
                  <c:pt idx="4">
                    <c:v>3.8616850542268613</c:v>
                  </c:pt>
                  <c:pt idx="5">
                    <c:v>3.7048863708270563</c:v>
                  </c:pt>
                  <c:pt idx="6">
                    <c:v>0.47999264577563272</c:v>
                  </c:pt>
                </c:numCache>
              </c:numRef>
            </c:minus>
          </c:errBars>
          <c:xVal>
            <c:numRef>
              <c:f>'PEO1 &amp; PEO4'!$B$40:$B$46</c:f>
              <c:numCache>
                <c:formatCode>General</c:formatCode>
                <c:ptCount val="7"/>
                <c:pt idx="0">
                  <c:v>0.46875</c:v>
                </c:pt>
                <c:pt idx="1">
                  <c:v>0.9375</c:v>
                </c:pt>
                <c:pt idx="2">
                  <c:v>1.875</c:v>
                </c:pt>
                <c:pt idx="3">
                  <c:v>3.75</c:v>
                </c:pt>
                <c:pt idx="4">
                  <c:v>7.5</c:v>
                </c:pt>
                <c:pt idx="5">
                  <c:v>15</c:v>
                </c:pt>
                <c:pt idx="6">
                  <c:v>30</c:v>
                </c:pt>
              </c:numCache>
            </c:numRef>
          </c:xVal>
          <c:yVal>
            <c:numRef>
              <c:f>'PEO1 &amp; PEO4'!$D$40:$D$46</c:f>
              <c:numCache>
                <c:formatCode>General</c:formatCode>
                <c:ptCount val="7"/>
                <c:pt idx="0">
                  <c:v>97.828152370772841</c:v>
                </c:pt>
                <c:pt idx="1">
                  <c:v>95.886404797957312</c:v>
                </c:pt>
                <c:pt idx="2">
                  <c:v>96.082360975030426</c:v>
                </c:pt>
                <c:pt idx="3">
                  <c:v>92.519521391882648</c:v>
                </c:pt>
                <c:pt idx="4">
                  <c:v>87.52620171610107</c:v>
                </c:pt>
                <c:pt idx="5">
                  <c:v>52.205991508565674</c:v>
                </c:pt>
                <c:pt idx="6">
                  <c:v>4.276892016270300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156-4B3C-A62D-5B1F69EA771A}"/>
            </c:ext>
          </c:extLst>
        </c:ser>
        <c:ser>
          <c:idx val="1"/>
          <c:order val="1"/>
          <c:tx>
            <c:strRef>
              <c:f>'PEO1 &amp; PEO4'!$B$68:$D$68</c:f>
              <c:strCache>
                <c:ptCount val="1"/>
                <c:pt idx="0">
                  <c:v>3PO &amp; 2nM Paclitaxel</c:v>
                </c:pt>
              </c:strCache>
            </c:strRef>
          </c:tx>
          <c:marker>
            <c:symbol val="square"/>
            <c:size val="4"/>
          </c:marker>
          <c:errBars>
            <c:errDir val="y"/>
            <c:errBarType val="both"/>
            <c:errValType val="cust"/>
            <c:noEndCap val="0"/>
            <c:plus>
              <c:numRef>
                <c:f>'PEO1&amp;PEO4 ERROR BARS'!$G$70:$G$76</c:f>
                <c:numCache>
                  <c:formatCode>General</c:formatCode>
                  <c:ptCount val="7"/>
                  <c:pt idx="0">
                    <c:v>0.8291356197400459</c:v>
                  </c:pt>
                  <c:pt idx="1">
                    <c:v>3.0604771280934386</c:v>
                  </c:pt>
                  <c:pt idx="2">
                    <c:v>2.1449063660713699</c:v>
                  </c:pt>
                  <c:pt idx="3">
                    <c:v>1.8983533488513644</c:v>
                  </c:pt>
                  <c:pt idx="4">
                    <c:v>2.9603048573981794</c:v>
                  </c:pt>
                  <c:pt idx="5">
                    <c:v>1.788344961058165</c:v>
                  </c:pt>
                  <c:pt idx="6">
                    <c:v>1.355553946558699</c:v>
                  </c:pt>
                </c:numCache>
              </c:numRef>
            </c:plus>
            <c:minus>
              <c:numRef>
                <c:f>'PEO1&amp;PEO4 ERROR BARS'!$G$70:$G$76</c:f>
                <c:numCache>
                  <c:formatCode>General</c:formatCode>
                  <c:ptCount val="7"/>
                  <c:pt idx="0">
                    <c:v>0.8291356197400459</c:v>
                  </c:pt>
                  <c:pt idx="1">
                    <c:v>3.0604771280934386</c:v>
                  </c:pt>
                  <c:pt idx="2">
                    <c:v>2.1449063660713699</c:v>
                  </c:pt>
                  <c:pt idx="3">
                    <c:v>1.8983533488513644</c:v>
                  </c:pt>
                  <c:pt idx="4">
                    <c:v>2.9603048573981794</c:v>
                  </c:pt>
                  <c:pt idx="5">
                    <c:v>1.788344961058165</c:v>
                  </c:pt>
                  <c:pt idx="6">
                    <c:v>1.355553946558699</c:v>
                  </c:pt>
                </c:numCache>
              </c:numRef>
            </c:minus>
          </c:errBars>
          <c:xVal>
            <c:numRef>
              <c:f>'PEO1 &amp; PEO4'!$B$70:$B$76</c:f>
              <c:numCache>
                <c:formatCode>General</c:formatCode>
                <c:ptCount val="7"/>
                <c:pt idx="0">
                  <c:v>0.46875</c:v>
                </c:pt>
                <c:pt idx="1">
                  <c:v>0.9375</c:v>
                </c:pt>
                <c:pt idx="2">
                  <c:v>1.875</c:v>
                </c:pt>
                <c:pt idx="3">
                  <c:v>3.75</c:v>
                </c:pt>
                <c:pt idx="4">
                  <c:v>7.5</c:v>
                </c:pt>
                <c:pt idx="5">
                  <c:v>15</c:v>
                </c:pt>
                <c:pt idx="6">
                  <c:v>30</c:v>
                </c:pt>
              </c:numCache>
            </c:numRef>
          </c:xVal>
          <c:yVal>
            <c:numRef>
              <c:f>'PEO1 &amp; PEO4'!$D$70:$D$76</c:f>
              <c:numCache>
                <c:formatCode>General</c:formatCode>
                <c:ptCount val="7"/>
                <c:pt idx="0">
                  <c:v>76.275941925714804</c:v>
                </c:pt>
                <c:pt idx="1">
                  <c:v>46.606395297051748</c:v>
                </c:pt>
                <c:pt idx="2">
                  <c:v>45.840384786674989</c:v>
                </c:pt>
                <c:pt idx="3">
                  <c:v>41.947982542086045</c:v>
                </c:pt>
                <c:pt idx="4">
                  <c:v>32.987440990469402</c:v>
                </c:pt>
                <c:pt idx="5">
                  <c:v>11.485704106172619</c:v>
                </c:pt>
                <c:pt idx="6">
                  <c:v>3.843413200320655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156-4B3C-A62D-5B1F69EA771A}"/>
            </c:ext>
          </c:extLst>
        </c:ser>
        <c:ser>
          <c:idx val="2"/>
          <c:order val="2"/>
          <c:tx>
            <c:strRef>
              <c:f>'PEO1 &amp; PEO4'!$E$69</c:f>
              <c:strCache>
                <c:ptCount val="1"/>
                <c:pt idx="0">
                  <c:v>2nM Paclitaxel</c:v>
                </c:pt>
              </c:strCache>
            </c:strRef>
          </c:tx>
          <c:marker>
            <c:symbol val="none"/>
          </c:marker>
          <c:xVal>
            <c:numRef>
              <c:f>'PEO1 &amp; PEO4'!$B$70:$B$76</c:f>
              <c:numCache>
                <c:formatCode>General</c:formatCode>
                <c:ptCount val="7"/>
                <c:pt idx="0">
                  <c:v>0.46875</c:v>
                </c:pt>
                <c:pt idx="1">
                  <c:v>0.9375</c:v>
                </c:pt>
                <c:pt idx="2">
                  <c:v>1.875</c:v>
                </c:pt>
                <c:pt idx="3">
                  <c:v>3.75</c:v>
                </c:pt>
                <c:pt idx="4">
                  <c:v>7.5</c:v>
                </c:pt>
                <c:pt idx="5">
                  <c:v>15</c:v>
                </c:pt>
                <c:pt idx="6">
                  <c:v>30</c:v>
                </c:pt>
              </c:numCache>
            </c:numRef>
          </c:xVal>
          <c:yVal>
            <c:numRef>
              <c:f>'PEO1 &amp; PEO4'!$E$70:$E$76</c:f>
              <c:numCache>
                <c:formatCode>General</c:formatCode>
                <c:ptCount val="7"/>
                <c:pt idx="0">
                  <c:v>91.935000000000002</c:v>
                </c:pt>
                <c:pt idx="1">
                  <c:v>91.935000000000002</c:v>
                </c:pt>
                <c:pt idx="2">
                  <c:v>91.935000000000002</c:v>
                </c:pt>
                <c:pt idx="3">
                  <c:v>91.935000000000002</c:v>
                </c:pt>
                <c:pt idx="4">
                  <c:v>91.935000000000002</c:v>
                </c:pt>
                <c:pt idx="5">
                  <c:v>91.935000000000002</c:v>
                </c:pt>
                <c:pt idx="6">
                  <c:v>91.935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156-4B3C-A62D-5B1F69EA77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761856"/>
        <c:axId val="198764032"/>
      </c:scatterChart>
      <c:valAx>
        <c:axId val="198761856"/>
        <c:scaling>
          <c:logBase val="1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/>
                  <a:t>3PO Concentration, </a:t>
                </a:r>
                <a:r>
                  <a:rPr lang="el-GR" sz="800"/>
                  <a:t>μ</a:t>
                </a:r>
                <a:r>
                  <a:rPr lang="en-US" sz="800"/>
                  <a:t>M</a:t>
                </a:r>
              </a:p>
            </c:rich>
          </c:tx>
          <c:layout>
            <c:manualLayout>
              <c:xMode val="edge"/>
              <c:yMode val="edge"/>
              <c:x val="0.36133496705768919"/>
              <c:y val="0.9103611696425271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98764032"/>
        <c:crosses val="autoZero"/>
        <c:crossBetween val="midCat"/>
      </c:valAx>
      <c:valAx>
        <c:axId val="19876403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% Cell Number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98761856"/>
        <c:crossesAt val="0.1"/>
        <c:crossBetween val="midCat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11920588838839681"/>
          <c:y val="0.55555625439614409"/>
          <c:w val="0.57008587672764466"/>
          <c:h val="0.23671774841948467"/>
        </c:manualLayout>
      </c:layout>
      <c:overlay val="0"/>
      <c:txPr>
        <a:bodyPr/>
        <a:lstStyle/>
        <a:p>
          <a:pPr>
            <a:defRPr sz="6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50"/>
            </a:pPr>
            <a:r>
              <a:rPr lang="en-US" sz="1050" dirty="0"/>
              <a:t>PEO4 - 3PO &amp; </a:t>
            </a:r>
            <a:r>
              <a:rPr lang="en-US" sz="1050" dirty="0" smtClean="0"/>
              <a:t>Paclitaxel</a:t>
            </a:r>
            <a:endParaRPr lang="en-US" sz="1050" dirty="0"/>
          </a:p>
        </c:rich>
      </c:tx>
      <c:layout>
        <c:manualLayout>
          <c:xMode val="edge"/>
          <c:yMode val="edge"/>
          <c:x val="0.20079187657764958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4725847233633313"/>
          <c:y val="0.11653177914583213"/>
          <c:w val="0.7934115019542155"/>
          <c:h val="0.6664328720445678"/>
        </c:manualLayout>
      </c:layout>
      <c:scatterChart>
        <c:scatterStyle val="lineMarker"/>
        <c:varyColors val="0"/>
        <c:ser>
          <c:idx val="0"/>
          <c:order val="0"/>
          <c:tx>
            <c:strRef>
              <c:f>'PEO1 &amp; PEO4'!$B$37:$F$37</c:f>
              <c:strCache>
                <c:ptCount val="1"/>
                <c:pt idx="0">
                  <c:v>3PO</c:v>
                </c:pt>
              </c:strCache>
            </c:strRef>
          </c:tx>
          <c:marker>
            <c:symbol val="diamond"/>
            <c:size val="4"/>
          </c:marker>
          <c:errBars>
            <c:errDir val="y"/>
            <c:errBarType val="both"/>
            <c:errValType val="cust"/>
            <c:noEndCap val="0"/>
            <c:plus>
              <c:numRef>
                <c:f>'PEO1&amp;PEO4 ERROR BARS'!$J$40:$J$46</c:f>
                <c:numCache>
                  <c:formatCode>General</c:formatCode>
                  <c:ptCount val="7"/>
                  <c:pt idx="0">
                    <c:v>1.5627811692433584</c:v>
                  </c:pt>
                  <c:pt idx="1">
                    <c:v>3.1831200411717711</c:v>
                  </c:pt>
                  <c:pt idx="2">
                    <c:v>3.357138960642625</c:v>
                  </c:pt>
                  <c:pt idx="3">
                    <c:v>2.5653162496830317</c:v>
                  </c:pt>
                  <c:pt idx="4">
                    <c:v>4.0820393412199323</c:v>
                  </c:pt>
                  <c:pt idx="5">
                    <c:v>1.8227663937617302</c:v>
                  </c:pt>
                  <c:pt idx="6">
                    <c:v>1.6923764489725681</c:v>
                  </c:pt>
                </c:numCache>
              </c:numRef>
            </c:plus>
            <c:minus>
              <c:numRef>
                <c:f>'PEO1&amp;PEO4 ERROR BARS'!$J$40:$J$46</c:f>
                <c:numCache>
                  <c:formatCode>General</c:formatCode>
                  <c:ptCount val="7"/>
                  <c:pt idx="0">
                    <c:v>1.5627811692433584</c:v>
                  </c:pt>
                  <c:pt idx="1">
                    <c:v>3.1831200411717711</c:v>
                  </c:pt>
                  <c:pt idx="2">
                    <c:v>3.357138960642625</c:v>
                  </c:pt>
                  <c:pt idx="3">
                    <c:v>2.5653162496830317</c:v>
                  </c:pt>
                  <c:pt idx="4">
                    <c:v>4.0820393412199323</c:v>
                  </c:pt>
                  <c:pt idx="5">
                    <c:v>1.8227663937617302</c:v>
                  </c:pt>
                  <c:pt idx="6">
                    <c:v>1.6923764489725681</c:v>
                  </c:pt>
                </c:numCache>
              </c:numRef>
            </c:minus>
          </c:errBars>
          <c:xVal>
            <c:numRef>
              <c:f>'PEO1 &amp; PEO4'!$B$40:$B$46</c:f>
              <c:numCache>
                <c:formatCode>General</c:formatCode>
                <c:ptCount val="7"/>
                <c:pt idx="0">
                  <c:v>0.46875</c:v>
                </c:pt>
                <c:pt idx="1">
                  <c:v>0.9375</c:v>
                </c:pt>
                <c:pt idx="2">
                  <c:v>1.875</c:v>
                </c:pt>
                <c:pt idx="3">
                  <c:v>3.75</c:v>
                </c:pt>
                <c:pt idx="4">
                  <c:v>7.5</c:v>
                </c:pt>
                <c:pt idx="5">
                  <c:v>15</c:v>
                </c:pt>
                <c:pt idx="6">
                  <c:v>30</c:v>
                </c:pt>
              </c:numCache>
            </c:numRef>
          </c:xVal>
          <c:yVal>
            <c:numRef>
              <c:f>'PEO1 &amp; PEO4'!$F$40:$F$46</c:f>
              <c:numCache>
                <c:formatCode>General</c:formatCode>
                <c:ptCount val="7"/>
                <c:pt idx="0">
                  <c:v>78.565858499929092</c:v>
                </c:pt>
                <c:pt idx="1">
                  <c:v>85.239614348504176</c:v>
                </c:pt>
                <c:pt idx="2">
                  <c:v>83.400680561463204</c:v>
                </c:pt>
                <c:pt idx="3">
                  <c:v>85.853537501772294</c:v>
                </c:pt>
                <c:pt idx="4">
                  <c:v>81.479512264284693</c:v>
                </c:pt>
                <c:pt idx="5">
                  <c:v>57.957606692187724</c:v>
                </c:pt>
                <c:pt idx="6">
                  <c:v>13.6218630370055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C42-480B-98A4-B26F12FD6A43}"/>
            </c:ext>
          </c:extLst>
        </c:ser>
        <c:ser>
          <c:idx val="1"/>
          <c:order val="1"/>
          <c:tx>
            <c:strRef>
              <c:f>'PEO1 &amp; PEO4'!$B$97:$D$97</c:f>
              <c:strCache>
                <c:ptCount val="1"/>
                <c:pt idx="0">
                  <c:v>3PO &amp; 2nM Paclitaxel</c:v>
                </c:pt>
              </c:strCache>
            </c:strRef>
          </c:tx>
          <c:marker>
            <c:symbol val="square"/>
            <c:size val="4"/>
          </c:marker>
          <c:errBars>
            <c:errDir val="y"/>
            <c:errBarType val="both"/>
            <c:errValType val="cust"/>
            <c:noEndCap val="0"/>
            <c:plus>
              <c:numRef>
                <c:f>'PEO1&amp;PEO4 ERROR BARS'!$G$99:$G$105</c:f>
                <c:numCache>
                  <c:formatCode>General</c:formatCode>
                  <c:ptCount val="7"/>
                  <c:pt idx="0">
                    <c:v>2.9328863175949191</c:v>
                  </c:pt>
                  <c:pt idx="1">
                    <c:v>1.9648112406600602</c:v>
                  </c:pt>
                  <c:pt idx="2">
                    <c:v>5.5299381477196112</c:v>
                  </c:pt>
                  <c:pt idx="3">
                    <c:v>1.8306238934040198</c:v>
                  </c:pt>
                  <c:pt idx="4">
                    <c:v>0.7679910712576693</c:v>
                  </c:pt>
                  <c:pt idx="5">
                    <c:v>2.3386952173385258</c:v>
                  </c:pt>
                  <c:pt idx="6">
                    <c:v>1.0291089731170189</c:v>
                  </c:pt>
                </c:numCache>
              </c:numRef>
            </c:plus>
            <c:minus>
              <c:numRef>
                <c:f>'PEO1&amp;PEO4 ERROR BARS'!$G$99:$G$105</c:f>
                <c:numCache>
                  <c:formatCode>General</c:formatCode>
                  <c:ptCount val="7"/>
                  <c:pt idx="0">
                    <c:v>2.9328863175949191</c:v>
                  </c:pt>
                  <c:pt idx="1">
                    <c:v>1.9648112406600602</c:v>
                  </c:pt>
                  <c:pt idx="2">
                    <c:v>5.5299381477196112</c:v>
                  </c:pt>
                  <c:pt idx="3">
                    <c:v>1.8306238934040198</c:v>
                  </c:pt>
                  <c:pt idx="4">
                    <c:v>0.7679910712576693</c:v>
                  </c:pt>
                  <c:pt idx="5">
                    <c:v>2.3386952173385258</c:v>
                  </c:pt>
                  <c:pt idx="6">
                    <c:v>1.0291089731170189</c:v>
                  </c:pt>
                </c:numCache>
              </c:numRef>
            </c:minus>
          </c:errBars>
          <c:xVal>
            <c:numRef>
              <c:f>'PEO1 &amp; PEO4'!$B$99:$B$105</c:f>
              <c:numCache>
                <c:formatCode>General</c:formatCode>
                <c:ptCount val="7"/>
                <c:pt idx="0">
                  <c:v>0.46875</c:v>
                </c:pt>
                <c:pt idx="1">
                  <c:v>0.9375</c:v>
                </c:pt>
                <c:pt idx="2">
                  <c:v>1.875</c:v>
                </c:pt>
                <c:pt idx="3">
                  <c:v>3.75</c:v>
                </c:pt>
                <c:pt idx="4">
                  <c:v>7.5</c:v>
                </c:pt>
                <c:pt idx="5">
                  <c:v>15</c:v>
                </c:pt>
                <c:pt idx="6">
                  <c:v>30</c:v>
                </c:pt>
              </c:numCache>
            </c:numRef>
          </c:xVal>
          <c:yVal>
            <c:numRef>
              <c:f>'PEO1 &amp; PEO4'!$D$99:$D$105</c:f>
              <c:numCache>
                <c:formatCode>General</c:formatCode>
                <c:ptCount val="7"/>
                <c:pt idx="0">
                  <c:v>59.992201899900756</c:v>
                </c:pt>
                <c:pt idx="1">
                  <c:v>62.976747483340425</c:v>
                </c:pt>
                <c:pt idx="2">
                  <c:v>60.145328229122356</c:v>
                </c:pt>
                <c:pt idx="3">
                  <c:v>64.44420813838083</c:v>
                </c:pt>
                <c:pt idx="4">
                  <c:v>57.184885864171264</c:v>
                </c:pt>
                <c:pt idx="5">
                  <c:v>35.98114277612364</c:v>
                </c:pt>
                <c:pt idx="6">
                  <c:v>7.12817240890401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C42-480B-98A4-B26F12FD6A43}"/>
            </c:ext>
          </c:extLst>
        </c:ser>
        <c:ser>
          <c:idx val="2"/>
          <c:order val="2"/>
          <c:tx>
            <c:strRef>
              <c:f>'PEO1 &amp; PEO4'!$E$98</c:f>
              <c:strCache>
                <c:ptCount val="1"/>
                <c:pt idx="0">
                  <c:v>2nM Paclitaxel</c:v>
                </c:pt>
              </c:strCache>
            </c:strRef>
          </c:tx>
          <c:marker>
            <c:symbol val="none"/>
          </c:marker>
          <c:xVal>
            <c:numRef>
              <c:f>'PEO1 &amp; PEO4'!$B$99:$B$105</c:f>
              <c:numCache>
                <c:formatCode>General</c:formatCode>
                <c:ptCount val="7"/>
                <c:pt idx="0">
                  <c:v>0.46875</c:v>
                </c:pt>
                <c:pt idx="1">
                  <c:v>0.9375</c:v>
                </c:pt>
                <c:pt idx="2">
                  <c:v>1.875</c:v>
                </c:pt>
                <c:pt idx="3">
                  <c:v>3.75</c:v>
                </c:pt>
                <c:pt idx="4">
                  <c:v>7.5</c:v>
                </c:pt>
                <c:pt idx="5">
                  <c:v>15</c:v>
                </c:pt>
                <c:pt idx="6">
                  <c:v>30</c:v>
                </c:pt>
              </c:numCache>
            </c:numRef>
          </c:xVal>
          <c:yVal>
            <c:numRef>
              <c:f>'PEO1 &amp; PEO4'!$E$99:$E$105</c:f>
              <c:numCache>
                <c:formatCode>General</c:formatCode>
                <c:ptCount val="7"/>
                <c:pt idx="0">
                  <c:v>74.915999999999997</c:v>
                </c:pt>
                <c:pt idx="1">
                  <c:v>74.915999999999997</c:v>
                </c:pt>
                <c:pt idx="2">
                  <c:v>74.915999999999997</c:v>
                </c:pt>
                <c:pt idx="3">
                  <c:v>74.915999999999997</c:v>
                </c:pt>
                <c:pt idx="4">
                  <c:v>74.915999999999997</c:v>
                </c:pt>
                <c:pt idx="5">
                  <c:v>74.915999999999997</c:v>
                </c:pt>
                <c:pt idx="6">
                  <c:v>74.915999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0C42-480B-98A4-B26F12FD6A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923008"/>
        <c:axId val="198924928"/>
      </c:scatterChart>
      <c:valAx>
        <c:axId val="198923008"/>
        <c:scaling>
          <c:logBase val="1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/>
                  <a:t>3PO Concentration, </a:t>
                </a:r>
                <a:r>
                  <a:rPr lang="el-GR" sz="800"/>
                  <a:t>μ</a:t>
                </a:r>
                <a:r>
                  <a:rPr lang="en-US" sz="800"/>
                  <a:t>M</a:t>
                </a:r>
              </a:p>
            </c:rich>
          </c:tx>
          <c:layout>
            <c:manualLayout>
              <c:xMode val="edge"/>
              <c:yMode val="edge"/>
              <c:x val="0.28926763093031704"/>
              <c:y val="0.8941936142305423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98924928"/>
        <c:crosses val="autoZero"/>
        <c:crossBetween val="midCat"/>
      </c:valAx>
      <c:valAx>
        <c:axId val="19892492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% Cell Number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198923008"/>
        <c:crossesAt val="0.1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17564841529149763"/>
          <c:y val="0.50733068504948475"/>
          <c:w val="0.52837712946153281"/>
          <c:h val="0.24865857934786625"/>
        </c:manualLayout>
      </c:layout>
      <c:overlay val="0"/>
      <c:txPr>
        <a:bodyPr/>
        <a:lstStyle/>
        <a:p>
          <a:pPr>
            <a:defRPr sz="6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50"/>
            </a:pPr>
            <a:r>
              <a:rPr lang="en-US" sz="1050" dirty="0"/>
              <a:t>PEO1 - </a:t>
            </a:r>
            <a:r>
              <a:rPr lang="en-US" sz="1050" dirty="0" err="1"/>
              <a:t>Oxamic</a:t>
            </a:r>
            <a:r>
              <a:rPr lang="en-US" sz="1050" dirty="0"/>
              <a:t> acid &amp; </a:t>
            </a:r>
            <a:r>
              <a:rPr lang="en-US" sz="1050" dirty="0" smtClean="0"/>
              <a:t>Metformin</a:t>
            </a:r>
            <a:endParaRPr lang="en-US" sz="1050" dirty="0"/>
          </a:p>
        </c:rich>
      </c:tx>
      <c:layout>
        <c:manualLayout>
          <c:xMode val="edge"/>
          <c:yMode val="edge"/>
          <c:x val="0.21376605507270111"/>
          <c:y val="1.2377205254731228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19633394551218"/>
          <c:y val="8.5631815266196273E-2"/>
          <c:w val="0.65590747716026998"/>
          <c:h val="0.65957937906895703"/>
        </c:manualLayout>
      </c:layout>
      <c:scatterChart>
        <c:scatterStyle val="lineMarker"/>
        <c:varyColors val="0"/>
        <c:ser>
          <c:idx val="0"/>
          <c:order val="0"/>
          <c:tx>
            <c:strRef>
              <c:f>'PEO1 &amp; PEO4'!$B$39:$F$39</c:f>
              <c:strCache>
                <c:ptCount val="1"/>
                <c:pt idx="0">
                  <c:v>Oxamic acid</c:v>
                </c:pt>
              </c:strCache>
            </c:strRef>
          </c:tx>
          <c:marker>
            <c:symbol val="diamond"/>
            <c:size val="4"/>
          </c:marker>
          <c:errBars>
            <c:errDir val="y"/>
            <c:errBarType val="both"/>
            <c:errValType val="cust"/>
            <c:noEndCap val="0"/>
            <c:plus>
              <c:numRef>
                <c:f>'PEO1&amp;PEO4 ERROR BARS'!$F$42:$F$48</c:f>
                <c:numCache>
                  <c:formatCode>General</c:formatCode>
                  <c:ptCount val="7"/>
                  <c:pt idx="0">
                    <c:v>5.542041599285227</c:v>
                  </c:pt>
                  <c:pt idx="1">
                    <c:v>6.2779349514705389</c:v>
                  </c:pt>
                  <c:pt idx="2">
                    <c:v>7.1873910322488657</c:v>
                  </c:pt>
                  <c:pt idx="3">
                    <c:v>4.9002260366776218</c:v>
                  </c:pt>
                  <c:pt idx="4">
                    <c:v>4.9825791979465865</c:v>
                  </c:pt>
                  <c:pt idx="5">
                    <c:v>2.4920201885127597</c:v>
                  </c:pt>
                  <c:pt idx="6">
                    <c:v>1.9249223013192869</c:v>
                  </c:pt>
                </c:numCache>
              </c:numRef>
            </c:plus>
            <c:minus>
              <c:numRef>
                <c:f>'PEO1&amp;PEO4 ERROR BARS'!$F$42:$F$48</c:f>
                <c:numCache>
                  <c:formatCode>General</c:formatCode>
                  <c:ptCount val="7"/>
                  <c:pt idx="0">
                    <c:v>5.542041599285227</c:v>
                  </c:pt>
                  <c:pt idx="1">
                    <c:v>6.2779349514705389</c:v>
                  </c:pt>
                  <c:pt idx="2">
                    <c:v>7.1873910322488657</c:v>
                  </c:pt>
                  <c:pt idx="3">
                    <c:v>4.9002260366776218</c:v>
                  </c:pt>
                  <c:pt idx="4">
                    <c:v>4.9825791979465865</c:v>
                  </c:pt>
                  <c:pt idx="5">
                    <c:v>2.4920201885127597</c:v>
                  </c:pt>
                  <c:pt idx="6">
                    <c:v>1.9249223013192869</c:v>
                  </c:pt>
                </c:numCache>
              </c:numRef>
            </c:minus>
          </c:errBars>
          <c:xVal>
            <c:numRef>
              <c:f>'PEO1 &amp; PEO4'!$B$42:$B$48</c:f>
              <c:numCache>
                <c:formatCode>General</c:formatCode>
                <c:ptCount val="7"/>
                <c:pt idx="0">
                  <c:v>1.5625</c:v>
                </c:pt>
                <c:pt idx="1">
                  <c:v>3.125</c:v>
                </c:pt>
                <c:pt idx="2">
                  <c:v>6.25</c:v>
                </c:pt>
                <c:pt idx="3">
                  <c:v>12.5</c:v>
                </c:pt>
                <c:pt idx="4">
                  <c:v>25</c:v>
                </c:pt>
                <c:pt idx="5">
                  <c:v>50</c:v>
                </c:pt>
                <c:pt idx="6">
                  <c:v>100</c:v>
                </c:pt>
              </c:numCache>
            </c:numRef>
          </c:xVal>
          <c:yVal>
            <c:numRef>
              <c:f>'PEO1 &amp; PEO4'!$D$42:$D$48</c:f>
              <c:numCache>
                <c:formatCode>General</c:formatCode>
                <c:ptCount val="7"/>
                <c:pt idx="0">
                  <c:v>98.073188570275676</c:v>
                </c:pt>
                <c:pt idx="1">
                  <c:v>92.462232982774722</c:v>
                </c:pt>
                <c:pt idx="2">
                  <c:v>80.949786890620672</c:v>
                </c:pt>
                <c:pt idx="3">
                  <c:v>52.2080149302666</c:v>
                </c:pt>
                <c:pt idx="4">
                  <c:v>34.718418198784398</c:v>
                </c:pt>
                <c:pt idx="5">
                  <c:v>23.003202945701247</c:v>
                </c:pt>
                <c:pt idx="6">
                  <c:v>19.76494918160954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92C-4809-92F3-8ADFF6573088}"/>
            </c:ext>
          </c:extLst>
        </c:ser>
        <c:ser>
          <c:idx val="1"/>
          <c:order val="1"/>
          <c:tx>
            <c:strRef>
              <c:f>'PEO1 &amp; PEO4'!$B$57:$D$57</c:f>
              <c:strCache>
                <c:ptCount val="1"/>
                <c:pt idx="0">
                  <c:v>Oxamic acid &amp; 2mM Metformin</c:v>
                </c:pt>
              </c:strCache>
            </c:strRef>
          </c:tx>
          <c:marker>
            <c:symbol val="square"/>
            <c:size val="4"/>
          </c:marker>
          <c:errBars>
            <c:errDir val="y"/>
            <c:errBarType val="both"/>
            <c:errValType val="cust"/>
            <c:noEndCap val="0"/>
            <c:plus>
              <c:numRef>
                <c:f>'PEO1&amp;PEO4 ERROR BARS'!$F$59:$F$65</c:f>
                <c:numCache>
                  <c:formatCode>General</c:formatCode>
                  <c:ptCount val="7"/>
                  <c:pt idx="0">
                    <c:v>4.2047652710648027</c:v>
                  </c:pt>
                  <c:pt idx="1">
                    <c:v>2.5587716153062621</c:v>
                  </c:pt>
                  <c:pt idx="2">
                    <c:v>3.8716230554259288</c:v>
                  </c:pt>
                  <c:pt idx="3">
                    <c:v>1.8597993680724214</c:v>
                  </c:pt>
                  <c:pt idx="4">
                    <c:v>2.9713691350784006</c:v>
                  </c:pt>
                  <c:pt idx="5">
                    <c:v>1.0830557342898377</c:v>
                  </c:pt>
                  <c:pt idx="6">
                    <c:v>2.1082557710149055</c:v>
                  </c:pt>
                </c:numCache>
              </c:numRef>
            </c:plus>
            <c:minus>
              <c:numRef>
                <c:f>'PEO1&amp;PEO4 ERROR BARS'!$F$59:$F$65</c:f>
                <c:numCache>
                  <c:formatCode>General</c:formatCode>
                  <c:ptCount val="7"/>
                  <c:pt idx="0">
                    <c:v>4.2047652710648027</c:v>
                  </c:pt>
                  <c:pt idx="1">
                    <c:v>2.5587716153062621</c:v>
                  </c:pt>
                  <c:pt idx="2">
                    <c:v>3.8716230554259288</c:v>
                  </c:pt>
                  <c:pt idx="3">
                    <c:v>1.8597993680724214</c:v>
                  </c:pt>
                  <c:pt idx="4">
                    <c:v>2.9713691350784006</c:v>
                  </c:pt>
                  <c:pt idx="5">
                    <c:v>1.0830557342898377</c:v>
                  </c:pt>
                  <c:pt idx="6">
                    <c:v>2.1082557710149055</c:v>
                  </c:pt>
                </c:numCache>
              </c:numRef>
            </c:minus>
          </c:errBars>
          <c:xVal>
            <c:numRef>
              <c:f>'PEO1 &amp; PEO4'!$B$59:$B$65</c:f>
              <c:numCache>
                <c:formatCode>General</c:formatCode>
                <c:ptCount val="7"/>
                <c:pt idx="0">
                  <c:v>1.5625</c:v>
                </c:pt>
                <c:pt idx="1">
                  <c:v>3.125</c:v>
                </c:pt>
                <c:pt idx="2">
                  <c:v>6.25</c:v>
                </c:pt>
                <c:pt idx="3">
                  <c:v>12.5</c:v>
                </c:pt>
                <c:pt idx="4">
                  <c:v>25</c:v>
                </c:pt>
                <c:pt idx="5">
                  <c:v>50</c:v>
                </c:pt>
                <c:pt idx="6">
                  <c:v>100</c:v>
                </c:pt>
              </c:numCache>
            </c:numRef>
          </c:xVal>
          <c:yVal>
            <c:numRef>
              <c:f>'PEO1 &amp; PEO4'!$D$59:$D$65</c:f>
              <c:numCache>
                <c:formatCode>General</c:formatCode>
                <c:ptCount val="7"/>
                <c:pt idx="0">
                  <c:v>70.023454641749282</c:v>
                </c:pt>
                <c:pt idx="1">
                  <c:v>28.652493001437545</c:v>
                </c:pt>
                <c:pt idx="2">
                  <c:v>25.807671937656057</c:v>
                </c:pt>
                <c:pt idx="3">
                  <c:v>18.090338200802002</c:v>
                </c:pt>
                <c:pt idx="4">
                  <c:v>22.962850873874562</c:v>
                </c:pt>
                <c:pt idx="5">
                  <c:v>15.50276159491564</c:v>
                </c:pt>
                <c:pt idx="6">
                  <c:v>17.63637739275176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92C-4809-92F3-8ADFF6573088}"/>
            </c:ext>
          </c:extLst>
        </c:ser>
        <c:ser>
          <c:idx val="2"/>
          <c:order val="2"/>
          <c:tx>
            <c:strRef>
              <c:f>'PEO1&amp;PEO4 ERROR BARS'!$G$58</c:f>
              <c:strCache>
                <c:ptCount val="1"/>
                <c:pt idx="0">
                  <c:v>2mM Metformin</c:v>
                </c:pt>
              </c:strCache>
            </c:strRef>
          </c:tx>
          <c:marker>
            <c:symbol val="none"/>
          </c:marker>
          <c:xVal>
            <c:numRef>
              <c:f>'PEO1&amp;PEO4 ERROR BARS'!$B$59:$B$65</c:f>
              <c:numCache>
                <c:formatCode>General</c:formatCode>
                <c:ptCount val="7"/>
                <c:pt idx="0">
                  <c:v>1.5625</c:v>
                </c:pt>
                <c:pt idx="1">
                  <c:v>3.125</c:v>
                </c:pt>
                <c:pt idx="2">
                  <c:v>6.25</c:v>
                </c:pt>
                <c:pt idx="3">
                  <c:v>12.5</c:v>
                </c:pt>
                <c:pt idx="4">
                  <c:v>25</c:v>
                </c:pt>
                <c:pt idx="5">
                  <c:v>50</c:v>
                </c:pt>
                <c:pt idx="6">
                  <c:v>100</c:v>
                </c:pt>
              </c:numCache>
            </c:numRef>
          </c:xVal>
          <c:yVal>
            <c:numRef>
              <c:f>'PEO1&amp;PEO4 ERROR BARS'!$G$59:$G$65</c:f>
              <c:numCache>
                <c:formatCode>General</c:formatCode>
                <c:ptCount val="7"/>
                <c:pt idx="0">
                  <c:v>94</c:v>
                </c:pt>
                <c:pt idx="1">
                  <c:v>94</c:v>
                </c:pt>
                <c:pt idx="2">
                  <c:v>94</c:v>
                </c:pt>
                <c:pt idx="3">
                  <c:v>94</c:v>
                </c:pt>
                <c:pt idx="4" formatCode="#,##0.000">
                  <c:v>94</c:v>
                </c:pt>
                <c:pt idx="5">
                  <c:v>94</c:v>
                </c:pt>
                <c:pt idx="6">
                  <c:v>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92C-4809-92F3-8ADFF65730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4051968"/>
        <c:axId val="224053888"/>
      </c:scatterChart>
      <c:valAx>
        <c:axId val="224051968"/>
        <c:scaling>
          <c:logBase val="1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/>
                  <a:t>Oxamic acid Concentration, mM</a:t>
                </a:r>
              </a:p>
            </c:rich>
          </c:tx>
          <c:layout>
            <c:manualLayout>
              <c:xMode val="edge"/>
              <c:yMode val="edge"/>
              <c:x val="0.270678582708482"/>
              <c:y val="0.8191466364972499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224053888"/>
        <c:crosses val="autoZero"/>
        <c:crossBetween val="midCat"/>
      </c:valAx>
      <c:valAx>
        <c:axId val="22405388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% Cell Number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224051968"/>
        <c:crossesAt val="0.1"/>
        <c:crossBetween val="midCat"/>
      </c:valAx>
    </c:plotArea>
    <c:legend>
      <c:legendPos val="r"/>
      <c:layout>
        <c:manualLayout>
          <c:xMode val="edge"/>
          <c:yMode val="edge"/>
          <c:x val="0.61974920163299685"/>
          <c:y val="0.27503649118908247"/>
          <c:w val="0.34979872128818373"/>
          <c:h val="0.29103200618203673"/>
        </c:manualLayout>
      </c:layout>
      <c:overlay val="0"/>
      <c:txPr>
        <a:bodyPr/>
        <a:lstStyle/>
        <a:p>
          <a:pPr>
            <a:defRPr sz="6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50"/>
            </a:pPr>
            <a:r>
              <a:rPr lang="en-US" sz="1050" dirty="0"/>
              <a:t>PEO4 - </a:t>
            </a:r>
            <a:r>
              <a:rPr lang="en-US" sz="1050" dirty="0" err="1"/>
              <a:t>Oxamic</a:t>
            </a:r>
            <a:r>
              <a:rPr lang="en-US" sz="1050" dirty="0"/>
              <a:t> acid &amp; </a:t>
            </a:r>
            <a:r>
              <a:rPr lang="en-US" sz="1050" dirty="0" smtClean="0"/>
              <a:t>Metformin</a:t>
            </a:r>
            <a:endParaRPr lang="en-US" sz="1050" dirty="0"/>
          </a:p>
        </c:rich>
      </c:tx>
      <c:layout>
        <c:manualLayout>
          <c:xMode val="edge"/>
          <c:yMode val="edge"/>
          <c:x val="0.24389125573535234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9505367966000967"/>
          <c:y val="8.6511644351062914E-2"/>
          <c:w val="0.64767885995870234"/>
          <c:h val="0.59496749885096945"/>
        </c:manualLayout>
      </c:layout>
      <c:scatterChart>
        <c:scatterStyle val="lineMarker"/>
        <c:varyColors val="0"/>
        <c:ser>
          <c:idx val="0"/>
          <c:order val="0"/>
          <c:tx>
            <c:strRef>
              <c:f>'PEO1 &amp; PEO4'!$B$39:$F$39</c:f>
              <c:strCache>
                <c:ptCount val="1"/>
                <c:pt idx="0">
                  <c:v>Oxamic acid</c:v>
                </c:pt>
              </c:strCache>
            </c:strRef>
          </c:tx>
          <c:marker>
            <c:symbol val="diamond"/>
            <c:size val="4"/>
          </c:marker>
          <c:errBars>
            <c:errDir val="y"/>
            <c:errBarType val="both"/>
            <c:errValType val="cust"/>
            <c:noEndCap val="0"/>
            <c:plus>
              <c:numRef>
                <c:f>'PEO1&amp;PEO4 ERROR BARS'!$J$42:$J$48</c:f>
                <c:numCache>
                  <c:formatCode>General</c:formatCode>
                  <c:ptCount val="7"/>
                  <c:pt idx="0">
                    <c:v>4.7862523390135925</c:v>
                  </c:pt>
                  <c:pt idx="1">
                    <c:v>5.6034391798116658</c:v>
                  </c:pt>
                  <c:pt idx="2">
                    <c:v>3.9013097346246814</c:v>
                  </c:pt>
                  <c:pt idx="3">
                    <c:v>4.4097131149045969</c:v>
                  </c:pt>
                  <c:pt idx="4">
                    <c:v>2.0518749537966401</c:v>
                  </c:pt>
                  <c:pt idx="5">
                    <c:v>2.5949116572606217</c:v>
                  </c:pt>
                  <c:pt idx="6">
                    <c:v>1.1164247797306979</c:v>
                  </c:pt>
                </c:numCache>
              </c:numRef>
            </c:plus>
            <c:minus>
              <c:numRef>
                <c:f>'PEO1&amp;PEO4 ERROR BARS'!$J$42:$J$48</c:f>
                <c:numCache>
                  <c:formatCode>General</c:formatCode>
                  <c:ptCount val="7"/>
                  <c:pt idx="0">
                    <c:v>4.7862523390135925</c:v>
                  </c:pt>
                  <c:pt idx="1">
                    <c:v>5.6034391798116658</c:v>
                  </c:pt>
                  <c:pt idx="2">
                    <c:v>3.9013097346246814</c:v>
                  </c:pt>
                  <c:pt idx="3">
                    <c:v>4.4097131149045969</c:v>
                  </c:pt>
                  <c:pt idx="4">
                    <c:v>2.0518749537966401</c:v>
                  </c:pt>
                  <c:pt idx="5">
                    <c:v>2.5949116572606217</c:v>
                  </c:pt>
                  <c:pt idx="6">
                    <c:v>1.1164247797306979</c:v>
                  </c:pt>
                </c:numCache>
              </c:numRef>
            </c:minus>
          </c:errBars>
          <c:xVal>
            <c:numRef>
              <c:f>'PEO1 &amp; PEO4'!$B$42:$B$48</c:f>
              <c:numCache>
                <c:formatCode>General</c:formatCode>
                <c:ptCount val="7"/>
                <c:pt idx="0">
                  <c:v>1.5625</c:v>
                </c:pt>
                <c:pt idx="1">
                  <c:v>3.125</c:v>
                </c:pt>
                <c:pt idx="2">
                  <c:v>6.25</c:v>
                </c:pt>
                <c:pt idx="3">
                  <c:v>12.5</c:v>
                </c:pt>
                <c:pt idx="4">
                  <c:v>25</c:v>
                </c:pt>
                <c:pt idx="5">
                  <c:v>50</c:v>
                </c:pt>
                <c:pt idx="6">
                  <c:v>100</c:v>
                </c:pt>
              </c:numCache>
            </c:numRef>
          </c:xVal>
          <c:yVal>
            <c:numRef>
              <c:f>'PEO1 &amp; PEO4'!$F$42:$F$48</c:f>
              <c:numCache>
                <c:formatCode>General</c:formatCode>
                <c:ptCount val="7"/>
                <c:pt idx="0">
                  <c:v>92.048725940377338</c:v>
                </c:pt>
                <c:pt idx="1">
                  <c:v>92.24857843020628</c:v>
                </c:pt>
                <c:pt idx="2">
                  <c:v>81.156765244700352</c:v>
                </c:pt>
                <c:pt idx="3">
                  <c:v>56.67483524065571</c:v>
                </c:pt>
                <c:pt idx="4">
                  <c:v>40.729461587875612</c:v>
                </c:pt>
                <c:pt idx="5">
                  <c:v>31.72182436772858</c:v>
                </c:pt>
                <c:pt idx="6">
                  <c:v>20.34450762532416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9D5-442A-8E9F-BA4410C34D7C}"/>
            </c:ext>
          </c:extLst>
        </c:ser>
        <c:ser>
          <c:idx val="1"/>
          <c:order val="1"/>
          <c:tx>
            <c:strRef>
              <c:f>'PEO1 &amp; PEO4'!$B$86:$D$86</c:f>
              <c:strCache>
                <c:ptCount val="1"/>
                <c:pt idx="0">
                  <c:v>Oxamic acid &amp; 0.5mM Metformin</c:v>
                </c:pt>
              </c:strCache>
            </c:strRef>
          </c:tx>
          <c:marker>
            <c:symbol val="square"/>
            <c:size val="4"/>
          </c:marker>
          <c:errBars>
            <c:errDir val="y"/>
            <c:errBarType val="both"/>
            <c:errValType val="cust"/>
            <c:noEndCap val="0"/>
            <c:plus>
              <c:numRef>
                <c:f>'PEO1&amp;PEO4 ERROR BARS'!$F$88:$F$94</c:f>
                <c:numCache>
                  <c:formatCode>General</c:formatCode>
                  <c:ptCount val="7"/>
                  <c:pt idx="0">
                    <c:v>4.747701820636645</c:v>
                  </c:pt>
                  <c:pt idx="1">
                    <c:v>6.5514388664696348</c:v>
                  </c:pt>
                  <c:pt idx="2">
                    <c:v>3.0869655383667589</c:v>
                  </c:pt>
                  <c:pt idx="3">
                    <c:v>2.8493197763269165</c:v>
                  </c:pt>
                  <c:pt idx="4">
                    <c:v>1.9063215950877894</c:v>
                  </c:pt>
                  <c:pt idx="5">
                    <c:v>1.0401110486166067</c:v>
                  </c:pt>
                  <c:pt idx="6">
                    <c:v>1.5430668295120087</c:v>
                  </c:pt>
                </c:numCache>
              </c:numRef>
            </c:plus>
            <c:minus>
              <c:numRef>
                <c:f>'PEO1&amp;PEO4 ERROR BARS'!$F$88:$F$94</c:f>
                <c:numCache>
                  <c:formatCode>General</c:formatCode>
                  <c:ptCount val="7"/>
                  <c:pt idx="0">
                    <c:v>4.747701820636645</c:v>
                  </c:pt>
                  <c:pt idx="1">
                    <c:v>6.5514388664696348</c:v>
                  </c:pt>
                  <c:pt idx="2">
                    <c:v>3.0869655383667589</c:v>
                  </c:pt>
                  <c:pt idx="3">
                    <c:v>2.8493197763269165</c:v>
                  </c:pt>
                  <c:pt idx="4">
                    <c:v>1.9063215950877894</c:v>
                  </c:pt>
                  <c:pt idx="5">
                    <c:v>1.0401110486166067</c:v>
                  </c:pt>
                  <c:pt idx="6">
                    <c:v>1.5430668295120087</c:v>
                  </c:pt>
                </c:numCache>
              </c:numRef>
            </c:minus>
          </c:errBars>
          <c:xVal>
            <c:numRef>
              <c:f>'PEO1 &amp; PEO4'!$B$88:$B$94</c:f>
              <c:numCache>
                <c:formatCode>General</c:formatCode>
                <c:ptCount val="7"/>
                <c:pt idx="0">
                  <c:v>1.5625</c:v>
                </c:pt>
                <c:pt idx="1">
                  <c:v>3.125</c:v>
                </c:pt>
                <c:pt idx="2">
                  <c:v>6.25</c:v>
                </c:pt>
                <c:pt idx="3">
                  <c:v>12.5</c:v>
                </c:pt>
                <c:pt idx="4">
                  <c:v>25</c:v>
                </c:pt>
                <c:pt idx="5">
                  <c:v>50</c:v>
                </c:pt>
                <c:pt idx="6">
                  <c:v>100</c:v>
                </c:pt>
              </c:numCache>
            </c:numRef>
          </c:xVal>
          <c:yVal>
            <c:numRef>
              <c:f>'PEO1 &amp; PEO4'!$D$88:$D$94</c:f>
              <c:numCache>
                <c:formatCode>General</c:formatCode>
                <c:ptCount val="7"/>
                <c:pt idx="0">
                  <c:v>105.57921534105779</c:v>
                </c:pt>
                <c:pt idx="1">
                  <c:v>42.708477076443586</c:v>
                </c:pt>
                <c:pt idx="2">
                  <c:v>25.324165496895144</c:v>
                </c:pt>
                <c:pt idx="3">
                  <c:v>26.30915276819491</c:v>
                </c:pt>
                <c:pt idx="4">
                  <c:v>24.924460517237275</c:v>
                </c:pt>
                <c:pt idx="5">
                  <c:v>21.170088744022269</c:v>
                </c:pt>
                <c:pt idx="6">
                  <c:v>13.10461326164021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9D5-442A-8E9F-BA4410C34D7C}"/>
            </c:ext>
          </c:extLst>
        </c:ser>
        <c:ser>
          <c:idx val="2"/>
          <c:order val="2"/>
          <c:tx>
            <c:strRef>
              <c:f>'PEO1&amp;PEO4 ERROR BARS'!$G$87</c:f>
              <c:strCache>
                <c:ptCount val="1"/>
                <c:pt idx="0">
                  <c:v>0.5mM Metformin</c:v>
                </c:pt>
              </c:strCache>
            </c:strRef>
          </c:tx>
          <c:marker>
            <c:symbol val="none"/>
          </c:marker>
          <c:xVal>
            <c:numRef>
              <c:f>'PEO1&amp;PEO4 ERROR BARS'!$B$88:$B$94</c:f>
              <c:numCache>
                <c:formatCode>General</c:formatCode>
                <c:ptCount val="7"/>
                <c:pt idx="0">
                  <c:v>1.5625</c:v>
                </c:pt>
                <c:pt idx="1">
                  <c:v>3.125</c:v>
                </c:pt>
                <c:pt idx="2">
                  <c:v>6.25</c:v>
                </c:pt>
                <c:pt idx="3">
                  <c:v>12.5</c:v>
                </c:pt>
                <c:pt idx="4">
                  <c:v>25</c:v>
                </c:pt>
                <c:pt idx="5">
                  <c:v>50</c:v>
                </c:pt>
                <c:pt idx="6">
                  <c:v>100</c:v>
                </c:pt>
              </c:numCache>
            </c:numRef>
          </c:xVal>
          <c:yVal>
            <c:numRef>
              <c:f>'PEO1&amp;PEO4 ERROR BARS'!$G$88:$G$94</c:f>
              <c:numCache>
                <c:formatCode>General</c:formatCode>
                <c:ptCount val="7"/>
                <c:pt idx="0">
                  <c:v>99</c:v>
                </c:pt>
                <c:pt idx="1">
                  <c:v>99</c:v>
                </c:pt>
                <c:pt idx="2">
                  <c:v>99</c:v>
                </c:pt>
                <c:pt idx="3">
                  <c:v>99</c:v>
                </c:pt>
                <c:pt idx="4" formatCode="#,##0.000">
                  <c:v>99</c:v>
                </c:pt>
                <c:pt idx="5">
                  <c:v>99</c:v>
                </c:pt>
                <c:pt idx="6">
                  <c:v>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9D5-442A-8E9F-BA4410C34D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3836032"/>
        <c:axId val="223838208"/>
      </c:scatterChart>
      <c:valAx>
        <c:axId val="223836032"/>
        <c:scaling>
          <c:logBase val="10"/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/>
                  <a:t>Oxamic acid Concentration, mM</a:t>
                </a:r>
              </a:p>
            </c:rich>
          </c:tx>
          <c:layout>
            <c:manualLayout>
              <c:xMode val="edge"/>
              <c:yMode val="edge"/>
              <c:x val="0.27492334585632433"/>
              <c:y val="0.7678316910193794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223838208"/>
        <c:crosses val="autoZero"/>
        <c:crossBetween val="midCat"/>
      </c:valAx>
      <c:valAx>
        <c:axId val="22383820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en-US" sz="800"/>
                  <a:t>% Cell Number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223836032"/>
        <c:crossesAt val="0.1"/>
        <c:crossBetween val="midCat"/>
      </c:valAx>
    </c:plotArea>
    <c:legend>
      <c:legendPos val="r"/>
      <c:layout>
        <c:manualLayout>
          <c:xMode val="edge"/>
          <c:yMode val="edge"/>
          <c:x val="0.51784465294046589"/>
          <c:y val="0.23664371972746512"/>
          <c:w val="0.47319104653648364"/>
          <c:h val="0.25554943861651669"/>
        </c:manualLayout>
      </c:layout>
      <c:overlay val="0"/>
      <c:txPr>
        <a:bodyPr/>
        <a:lstStyle/>
        <a:p>
          <a:pPr>
            <a:defRPr sz="6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.90617</cdr:y>
    </cdr:from>
    <cdr:to>
      <cdr:x>0.27768</cdr:x>
      <cdr:y>1</cdr:y>
    </cdr:to>
    <cdr:sp macro="" textlink="">
      <cdr:nvSpPr>
        <cdr:cNvPr id="2" name="Text Box 1"/>
        <cdr:cNvSpPr txBox="1"/>
      </cdr:nvSpPr>
      <cdr:spPr>
        <a:xfrm xmlns:a="http://schemas.openxmlformats.org/drawingml/2006/main">
          <a:off x="0" y="1794163"/>
          <a:ext cx="699655" cy="18576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GB" sz="800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6371</cdr:x>
      <cdr:y>0.50789</cdr:y>
    </cdr:from>
    <cdr:to>
      <cdr:x>1</cdr:x>
      <cdr:y>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605281" y="943714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800" dirty="0" smtClean="0"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en-GB" sz="8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</cdr:x>
      <cdr:y>0.90268</cdr:y>
    </cdr:from>
    <cdr:to>
      <cdr:x>0.30242</cdr:x>
      <cdr:y>1</cdr:y>
    </cdr:to>
    <cdr:sp macro="" textlink="">
      <cdr:nvSpPr>
        <cdr:cNvPr id="2" name="Text Box 1"/>
        <cdr:cNvSpPr txBox="1"/>
      </cdr:nvSpPr>
      <cdr:spPr>
        <a:xfrm xmlns:a="http://schemas.openxmlformats.org/drawingml/2006/main">
          <a:off x="0" y="1787236"/>
          <a:ext cx="761999" cy="19269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GB" sz="800" dirty="0"/>
        </a:p>
      </cdr:txBody>
    </cdr:sp>
  </cdr:relSizeAnchor>
  <cdr:relSizeAnchor xmlns:cdr="http://schemas.openxmlformats.org/drawingml/2006/chartDrawing">
    <cdr:from>
      <cdr:x>0.39114</cdr:x>
      <cdr:y>0.5</cdr:y>
    </cdr:from>
    <cdr:to>
      <cdr:x>0.77565</cdr:x>
      <cdr:y>0.97926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930171" y="953961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GB" sz="1100" dirty="0"/>
        </a:p>
      </cdr:txBody>
    </cdr:sp>
  </cdr:relSizeAnchor>
  <cdr:relSizeAnchor xmlns:cdr="http://schemas.openxmlformats.org/drawingml/2006/chartDrawing">
    <cdr:from>
      <cdr:x>0.36134</cdr:x>
      <cdr:y>0.41837</cdr:y>
    </cdr:from>
    <cdr:to>
      <cdr:x>0.74585</cdr:x>
      <cdr:y>0.89764</cdr:y>
    </cdr:to>
    <cdr:sp macro="" textlink="">
      <cdr:nvSpPr>
        <cdr:cNvPr id="4" name="TextBox 3"/>
        <cdr:cNvSpPr txBox="1"/>
      </cdr:nvSpPr>
      <cdr:spPr>
        <a:xfrm xmlns:a="http://schemas.openxmlformats.org/drawingml/2006/main">
          <a:off x="859304" y="798221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800" dirty="0" smtClean="0"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en-GB" sz="8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6523</cdr:x>
      <cdr:y>0.5</cdr:y>
    </cdr:from>
    <cdr:to>
      <cdr:x>0.84973</cdr:x>
      <cdr:y>0.97926</cdr:y>
    </cdr:to>
    <cdr:sp macro="" textlink="">
      <cdr:nvSpPr>
        <cdr:cNvPr id="5" name="TextBox 4"/>
        <cdr:cNvSpPr txBox="1"/>
      </cdr:nvSpPr>
      <cdr:spPr>
        <a:xfrm xmlns:a="http://schemas.openxmlformats.org/drawingml/2006/main">
          <a:off x="1106355" y="953961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GB" sz="1100" dirty="0"/>
        </a:p>
      </cdr:txBody>
    </cdr:sp>
  </cdr:relSizeAnchor>
  <cdr:relSizeAnchor xmlns:cdr="http://schemas.openxmlformats.org/drawingml/2006/chartDrawing">
    <cdr:from>
      <cdr:x>0.43796</cdr:x>
      <cdr:y>0.46165</cdr:y>
    </cdr:from>
    <cdr:to>
      <cdr:x>0.82247</cdr:x>
      <cdr:y>0.94091</cdr:y>
    </cdr:to>
    <cdr:sp macro="" textlink="">
      <cdr:nvSpPr>
        <cdr:cNvPr id="6" name="TextBox 5"/>
        <cdr:cNvSpPr txBox="1"/>
      </cdr:nvSpPr>
      <cdr:spPr>
        <a:xfrm xmlns:a="http://schemas.openxmlformats.org/drawingml/2006/main">
          <a:off x="1041521" y="880791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800" dirty="0" smtClean="0"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en-GB" sz="8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</cdr:x>
      <cdr:y>0.90617</cdr:y>
    </cdr:from>
    <cdr:to>
      <cdr:x>0.30242</cdr:x>
      <cdr:y>1</cdr:y>
    </cdr:to>
    <cdr:sp macro="" textlink="">
      <cdr:nvSpPr>
        <cdr:cNvPr id="2" name="Text Box 1"/>
        <cdr:cNvSpPr txBox="1"/>
      </cdr:nvSpPr>
      <cdr:spPr>
        <a:xfrm xmlns:a="http://schemas.openxmlformats.org/drawingml/2006/main">
          <a:off x="0" y="1794163"/>
          <a:ext cx="762000" cy="18576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GB" sz="800" dirty="0"/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</cdr:x>
      <cdr:y>0.90967</cdr:y>
    </cdr:from>
    <cdr:to>
      <cdr:x>0.30517</cdr:x>
      <cdr:y>1</cdr:y>
    </cdr:to>
    <cdr:sp macro="" textlink="">
      <cdr:nvSpPr>
        <cdr:cNvPr id="2" name="Text Box 1"/>
        <cdr:cNvSpPr txBox="1"/>
      </cdr:nvSpPr>
      <cdr:spPr>
        <a:xfrm xmlns:a="http://schemas.openxmlformats.org/drawingml/2006/main">
          <a:off x="0" y="1801091"/>
          <a:ext cx="768928" cy="17883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GB" sz="8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41F9C-72DF-4BDD-AB21-8EB611183E57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CC502-92BA-4ACF-AE31-927753F922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40051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41F9C-72DF-4BDD-AB21-8EB611183E57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CC502-92BA-4ACF-AE31-927753F922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5045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41F9C-72DF-4BDD-AB21-8EB611183E57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CC502-92BA-4ACF-AE31-927753F922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4768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41F9C-72DF-4BDD-AB21-8EB611183E57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CC502-92BA-4ACF-AE31-927753F922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79447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41F9C-72DF-4BDD-AB21-8EB611183E57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CC502-92BA-4ACF-AE31-927753F922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5595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41F9C-72DF-4BDD-AB21-8EB611183E57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CC502-92BA-4ACF-AE31-927753F922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72299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41F9C-72DF-4BDD-AB21-8EB611183E57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CC502-92BA-4ACF-AE31-927753F922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469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41F9C-72DF-4BDD-AB21-8EB611183E57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CC502-92BA-4ACF-AE31-927753F922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42345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41F9C-72DF-4BDD-AB21-8EB611183E57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CC502-92BA-4ACF-AE31-927753F922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5328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41F9C-72DF-4BDD-AB21-8EB611183E57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CC502-92BA-4ACF-AE31-927753F922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58229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41F9C-72DF-4BDD-AB21-8EB611183E57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0CC502-92BA-4ACF-AE31-927753F922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7095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841F9C-72DF-4BDD-AB21-8EB611183E57}" type="datetimeFigureOut">
              <a:rPr lang="en-GB" smtClean="0"/>
              <a:t>08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0CC502-92BA-4ACF-AE31-927753F922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93227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07504" y="125569"/>
            <a:ext cx="1847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GB" sz="2000" b="1" dirty="0"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44274" y="3636160"/>
            <a:ext cx="3978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cs typeface="Times New Roman" panose="02020603050405020304" pitchFamily="18" charset="0"/>
              </a:rPr>
              <a:t>B.</a:t>
            </a:r>
            <a:endParaRPr lang="en-GB" sz="2000" b="1" dirty="0"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70283" y="634702"/>
            <a:ext cx="4109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+mj-lt"/>
                <a:cs typeface="Times New Roman" panose="02020603050405020304" pitchFamily="18" charset="0"/>
              </a:rPr>
              <a:t>A.</a:t>
            </a:r>
            <a:endParaRPr lang="en-GB" sz="2000" b="1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686780" y="915945"/>
            <a:ext cx="3898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+mj-lt"/>
                <a:cs typeface="Times New Roman" panose="02020603050405020304" pitchFamily="18" charset="0"/>
              </a:rPr>
              <a:t>C.</a:t>
            </a:r>
            <a:endParaRPr lang="en-GB" sz="2000" b="1" dirty="0">
              <a:latin typeface="+mj-lt"/>
              <a:cs typeface="Times New Roman" panose="02020603050405020304" pitchFamily="18" charset="0"/>
            </a:endParaRPr>
          </a:p>
        </p:txBody>
      </p:sp>
      <p:graphicFrame>
        <p:nvGraphicFramePr>
          <p:cNvPr id="23" name="Chart 22"/>
          <p:cNvGraphicFramePr/>
          <p:nvPr>
            <p:extLst>
              <p:ext uri="{D42A27DB-BD31-4B8C-83A1-F6EECF244321}">
                <p14:modId xmlns:p14="http://schemas.microsoft.com/office/powerpoint/2010/main" val="926562475"/>
              </p:ext>
            </p:extLst>
          </p:nvPr>
        </p:nvGraphicFramePr>
        <p:xfrm>
          <a:off x="520026" y="1025358"/>
          <a:ext cx="2242938" cy="16835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5" name="Chart 24"/>
          <p:cNvGraphicFramePr/>
          <p:nvPr>
            <p:extLst>
              <p:ext uri="{D42A27DB-BD31-4B8C-83A1-F6EECF244321}">
                <p14:modId xmlns:p14="http://schemas.microsoft.com/office/powerpoint/2010/main" val="3457918786"/>
              </p:ext>
            </p:extLst>
          </p:nvPr>
        </p:nvGraphicFramePr>
        <p:xfrm>
          <a:off x="2762964" y="804989"/>
          <a:ext cx="2519681" cy="18581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6" name="Chart 25"/>
          <p:cNvGraphicFramePr/>
          <p:nvPr>
            <p:extLst>
              <p:ext uri="{D42A27DB-BD31-4B8C-83A1-F6EECF244321}">
                <p14:modId xmlns:p14="http://schemas.microsoft.com/office/powerpoint/2010/main" val="590699251"/>
              </p:ext>
            </p:extLst>
          </p:nvPr>
        </p:nvGraphicFramePr>
        <p:xfrm>
          <a:off x="535140" y="3926923"/>
          <a:ext cx="2378104" cy="19079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7" name="Chart 26"/>
          <p:cNvGraphicFramePr/>
          <p:nvPr>
            <p:extLst>
              <p:ext uri="{D42A27DB-BD31-4B8C-83A1-F6EECF244321}">
                <p14:modId xmlns:p14="http://schemas.microsoft.com/office/powerpoint/2010/main" val="1845880519"/>
              </p:ext>
            </p:extLst>
          </p:nvPr>
        </p:nvGraphicFramePr>
        <p:xfrm>
          <a:off x="2869281" y="4005064"/>
          <a:ext cx="2355165" cy="19204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7" name="Chart 16"/>
          <p:cNvGraphicFramePr/>
          <p:nvPr>
            <p:extLst>
              <p:ext uri="{D42A27DB-BD31-4B8C-83A1-F6EECF244321}">
                <p14:modId xmlns:p14="http://schemas.microsoft.com/office/powerpoint/2010/main" val="1818351555"/>
              </p:ext>
            </p:extLst>
          </p:nvPr>
        </p:nvGraphicFramePr>
        <p:xfrm>
          <a:off x="5987163" y="1308423"/>
          <a:ext cx="2735584" cy="19799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8" name="Chart 17"/>
          <p:cNvGraphicFramePr/>
          <p:nvPr>
            <p:extLst>
              <p:ext uri="{D42A27DB-BD31-4B8C-83A1-F6EECF244321}">
                <p14:modId xmlns:p14="http://schemas.microsoft.com/office/powerpoint/2010/main" val="3758583162"/>
              </p:ext>
            </p:extLst>
          </p:nvPr>
        </p:nvGraphicFramePr>
        <p:xfrm>
          <a:off x="5955888" y="3284984"/>
          <a:ext cx="2872317" cy="19799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707998" y="1681777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851644" y="1757753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033861" y="2054546"/>
            <a:ext cx="2247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838565" y="1466333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860398" y="1834177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001634" y="1533919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190824" y="1555341"/>
            <a:ext cx="2247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1"/>
          <p:cNvSpPr txBox="1"/>
          <p:nvPr/>
        </p:nvSpPr>
        <p:spPr>
          <a:xfrm>
            <a:off x="1738786" y="4853269"/>
            <a:ext cx="914400" cy="9144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1"/>
          <p:cNvSpPr txBox="1"/>
          <p:nvPr/>
        </p:nvSpPr>
        <p:spPr>
          <a:xfrm>
            <a:off x="1916538" y="4920445"/>
            <a:ext cx="914400" cy="9144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1"/>
          <p:cNvSpPr txBox="1"/>
          <p:nvPr/>
        </p:nvSpPr>
        <p:spPr>
          <a:xfrm>
            <a:off x="2104507" y="5198280"/>
            <a:ext cx="914400" cy="9144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1"/>
          <p:cNvSpPr txBox="1"/>
          <p:nvPr/>
        </p:nvSpPr>
        <p:spPr>
          <a:xfrm>
            <a:off x="4457851" y="4853269"/>
            <a:ext cx="914400" cy="9144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1"/>
          <p:cNvSpPr txBox="1"/>
          <p:nvPr/>
        </p:nvSpPr>
        <p:spPr>
          <a:xfrm>
            <a:off x="6804248" y="2269990"/>
            <a:ext cx="914400" cy="9144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1"/>
          <p:cNvSpPr txBox="1"/>
          <p:nvPr/>
        </p:nvSpPr>
        <p:spPr>
          <a:xfrm>
            <a:off x="7104631" y="2298388"/>
            <a:ext cx="914400" cy="9144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1"/>
          <p:cNvSpPr txBox="1"/>
          <p:nvPr/>
        </p:nvSpPr>
        <p:spPr>
          <a:xfrm>
            <a:off x="7373469" y="2398982"/>
            <a:ext cx="914400" cy="9144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1"/>
          <p:cNvSpPr txBox="1"/>
          <p:nvPr/>
        </p:nvSpPr>
        <p:spPr>
          <a:xfrm>
            <a:off x="7642307" y="2499576"/>
            <a:ext cx="914400" cy="9144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1"/>
          <p:cNvSpPr txBox="1"/>
          <p:nvPr/>
        </p:nvSpPr>
        <p:spPr>
          <a:xfrm>
            <a:off x="7891367" y="2594290"/>
            <a:ext cx="914400" cy="9144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1"/>
          <p:cNvSpPr txBox="1"/>
          <p:nvPr/>
        </p:nvSpPr>
        <p:spPr>
          <a:xfrm>
            <a:off x="6897755" y="3979047"/>
            <a:ext cx="914400" cy="9144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1"/>
          <p:cNvSpPr txBox="1"/>
          <p:nvPr/>
        </p:nvSpPr>
        <p:spPr>
          <a:xfrm>
            <a:off x="7117703" y="4211093"/>
            <a:ext cx="914400" cy="9144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1"/>
          <p:cNvSpPr txBox="1"/>
          <p:nvPr/>
        </p:nvSpPr>
        <p:spPr>
          <a:xfrm>
            <a:off x="7429816" y="4218409"/>
            <a:ext cx="914400" cy="9144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1"/>
          <p:cNvSpPr txBox="1"/>
          <p:nvPr/>
        </p:nvSpPr>
        <p:spPr>
          <a:xfrm>
            <a:off x="7698600" y="4229410"/>
            <a:ext cx="914400" cy="9144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1"/>
          <p:cNvSpPr txBox="1"/>
          <p:nvPr/>
        </p:nvSpPr>
        <p:spPr>
          <a:xfrm>
            <a:off x="7994619" y="4396069"/>
            <a:ext cx="914400" cy="91440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49826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50</TotalTime>
  <Words>109</Words>
  <Application>Microsoft Office PowerPoint</Application>
  <PresentationFormat>On-screen Show (4:3)</PresentationFormat>
  <Paragraphs>4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ysi Xintaropoulou</dc:creator>
  <cp:lastModifiedBy>LANGDON Simon</cp:lastModifiedBy>
  <cp:revision>92</cp:revision>
  <dcterms:created xsi:type="dcterms:W3CDTF">2017-01-10T18:51:10Z</dcterms:created>
  <dcterms:modified xsi:type="dcterms:W3CDTF">2018-05-08T09:49:58Z</dcterms:modified>
</cp:coreProperties>
</file>